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8" d="100"/>
          <a:sy n="68" d="100"/>
        </p:scale>
        <p:origin x="1446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amareille:Desktop:repre&#769;sentation%20CRC%20individuelles%20Fig%20S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Feuil1!$B$2</c:f>
              <c:strCache>
                <c:ptCount val="1"/>
              </c:strCache>
            </c:strRef>
          </c:tx>
          <c:spPr>
            <a:ln w="28575" cap="rnd" cmpd="sng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Feuil1!$A$3:$A$202</c:f>
              <c:numCache>
                <c:formatCode>0.00</c:formatCode>
                <c:ptCount val="200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  <c:pt idx="25">
                  <c:v>125</c:v>
                </c:pt>
                <c:pt idx="26">
                  <c:v>130</c:v>
                </c:pt>
                <c:pt idx="27">
                  <c:v>135</c:v>
                </c:pt>
                <c:pt idx="28">
                  <c:v>140</c:v>
                </c:pt>
                <c:pt idx="29">
                  <c:v>145</c:v>
                </c:pt>
                <c:pt idx="30">
                  <c:v>150</c:v>
                </c:pt>
                <c:pt idx="31">
                  <c:v>155</c:v>
                </c:pt>
                <c:pt idx="32" formatCode="General">
                  <c:v>160</c:v>
                </c:pt>
                <c:pt idx="33" formatCode="General">
                  <c:v>165</c:v>
                </c:pt>
                <c:pt idx="34" formatCode="General">
                  <c:v>170</c:v>
                </c:pt>
                <c:pt idx="35" formatCode="General">
                  <c:v>175</c:v>
                </c:pt>
                <c:pt idx="36" formatCode="General">
                  <c:v>180</c:v>
                </c:pt>
                <c:pt idx="37" formatCode="General">
                  <c:v>185</c:v>
                </c:pt>
                <c:pt idx="38" formatCode="General">
                  <c:v>190</c:v>
                </c:pt>
                <c:pt idx="39" formatCode="General">
                  <c:v>195</c:v>
                </c:pt>
                <c:pt idx="40" formatCode="General">
                  <c:v>200</c:v>
                </c:pt>
                <c:pt idx="41" formatCode="General">
                  <c:v>205</c:v>
                </c:pt>
                <c:pt idx="42" formatCode="General">
                  <c:v>210</c:v>
                </c:pt>
                <c:pt idx="43" formatCode="General">
                  <c:v>215</c:v>
                </c:pt>
                <c:pt idx="44" formatCode="General">
                  <c:v>220</c:v>
                </c:pt>
                <c:pt idx="45" formatCode="General">
                  <c:v>225</c:v>
                </c:pt>
                <c:pt idx="46" formatCode="General">
                  <c:v>230</c:v>
                </c:pt>
                <c:pt idx="47" formatCode="General">
                  <c:v>235</c:v>
                </c:pt>
                <c:pt idx="48" formatCode="General">
                  <c:v>240</c:v>
                </c:pt>
                <c:pt idx="49" formatCode="General">
                  <c:v>245</c:v>
                </c:pt>
                <c:pt idx="50" formatCode="General">
                  <c:v>250</c:v>
                </c:pt>
                <c:pt idx="51" formatCode="General">
                  <c:v>255</c:v>
                </c:pt>
                <c:pt idx="52" formatCode="General">
                  <c:v>260</c:v>
                </c:pt>
                <c:pt idx="53" formatCode="General">
                  <c:v>265</c:v>
                </c:pt>
                <c:pt idx="54" formatCode="General">
                  <c:v>270</c:v>
                </c:pt>
                <c:pt idx="55" formatCode="General">
                  <c:v>275</c:v>
                </c:pt>
                <c:pt idx="56" formatCode="General">
                  <c:v>280</c:v>
                </c:pt>
                <c:pt idx="57" formatCode="General">
                  <c:v>285</c:v>
                </c:pt>
                <c:pt idx="58" formatCode="General">
                  <c:v>290</c:v>
                </c:pt>
                <c:pt idx="59" formatCode="General">
                  <c:v>295</c:v>
                </c:pt>
                <c:pt idx="60" formatCode="General">
                  <c:v>300</c:v>
                </c:pt>
                <c:pt idx="61" formatCode="General">
                  <c:v>305</c:v>
                </c:pt>
                <c:pt idx="62" formatCode="General">
                  <c:v>310</c:v>
                </c:pt>
                <c:pt idx="63" formatCode="General">
                  <c:v>315</c:v>
                </c:pt>
                <c:pt idx="64" formatCode="General">
                  <c:v>320</c:v>
                </c:pt>
                <c:pt idx="65" formatCode="General">
                  <c:v>325</c:v>
                </c:pt>
                <c:pt idx="66" formatCode="General">
                  <c:v>330</c:v>
                </c:pt>
                <c:pt idx="67" formatCode="General">
                  <c:v>335</c:v>
                </c:pt>
                <c:pt idx="68" formatCode="General">
                  <c:v>340</c:v>
                </c:pt>
                <c:pt idx="69" formatCode="General">
                  <c:v>345</c:v>
                </c:pt>
                <c:pt idx="70" formatCode="General">
                  <c:v>350</c:v>
                </c:pt>
                <c:pt idx="71" formatCode="General">
                  <c:v>355</c:v>
                </c:pt>
                <c:pt idx="72" formatCode="General">
                  <c:v>360</c:v>
                </c:pt>
                <c:pt idx="73" formatCode="General">
                  <c:v>365</c:v>
                </c:pt>
                <c:pt idx="74" formatCode="General">
                  <c:v>370</c:v>
                </c:pt>
                <c:pt idx="75" formatCode="General">
                  <c:v>375</c:v>
                </c:pt>
                <c:pt idx="76" formatCode="General">
                  <c:v>380</c:v>
                </c:pt>
                <c:pt idx="77" formatCode="General">
                  <c:v>385</c:v>
                </c:pt>
                <c:pt idx="78" formatCode="General">
                  <c:v>390</c:v>
                </c:pt>
                <c:pt idx="79" formatCode="General">
                  <c:v>395</c:v>
                </c:pt>
                <c:pt idx="80" formatCode="General">
                  <c:v>400</c:v>
                </c:pt>
                <c:pt idx="81" formatCode="General">
                  <c:v>405</c:v>
                </c:pt>
                <c:pt idx="82" formatCode="General">
                  <c:v>410</c:v>
                </c:pt>
                <c:pt idx="83" formatCode="General">
                  <c:v>415</c:v>
                </c:pt>
                <c:pt idx="84" formatCode="General">
                  <c:v>420</c:v>
                </c:pt>
                <c:pt idx="85" formatCode="General">
                  <c:v>425</c:v>
                </c:pt>
                <c:pt idx="86" formatCode="General">
                  <c:v>430</c:v>
                </c:pt>
                <c:pt idx="87" formatCode="General">
                  <c:v>435</c:v>
                </c:pt>
                <c:pt idx="88" formatCode="General">
                  <c:v>440</c:v>
                </c:pt>
                <c:pt idx="89" formatCode="General">
                  <c:v>445</c:v>
                </c:pt>
                <c:pt idx="90" formatCode="General">
                  <c:v>450</c:v>
                </c:pt>
                <c:pt idx="91" formatCode="General">
                  <c:v>455</c:v>
                </c:pt>
                <c:pt idx="92" formatCode="General">
                  <c:v>460</c:v>
                </c:pt>
                <c:pt idx="93" formatCode="General">
                  <c:v>465</c:v>
                </c:pt>
                <c:pt idx="94" formatCode="General">
                  <c:v>470</c:v>
                </c:pt>
                <c:pt idx="95" formatCode="General">
                  <c:v>475</c:v>
                </c:pt>
                <c:pt idx="96" formatCode="General">
                  <c:v>480</c:v>
                </c:pt>
                <c:pt idx="97" formatCode="General">
                  <c:v>485</c:v>
                </c:pt>
                <c:pt idx="98" formatCode="General">
                  <c:v>490</c:v>
                </c:pt>
                <c:pt idx="99" formatCode="General">
                  <c:v>495</c:v>
                </c:pt>
                <c:pt idx="100" formatCode="General">
                  <c:v>500</c:v>
                </c:pt>
                <c:pt idx="101" formatCode="General">
                  <c:v>505</c:v>
                </c:pt>
                <c:pt idx="102" formatCode="General">
                  <c:v>510</c:v>
                </c:pt>
                <c:pt idx="103" formatCode="General">
                  <c:v>515</c:v>
                </c:pt>
                <c:pt idx="104" formatCode="General">
                  <c:v>520</c:v>
                </c:pt>
                <c:pt idx="105" formatCode="General">
                  <c:v>525</c:v>
                </c:pt>
                <c:pt idx="106" formatCode="General">
                  <c:v>530</c:v>
                </c:pt>
                <c:pt idx="107" formatCode="General">
                  <c:v>535</c:v>
                </c:pt>
                <c:pt idx="108" formatCode="General">
                  <c:v>540</c:v>
                </c:pt>
                <c:pt idx="109" formatCode="General">
                  <c:v>545</c:v>
                </c:pt>
                <c:pt idx="110" formatCode="General">
                  <c:v>550</c:v>
                </c:pt>
                <c:pt idx="111" formatCode="General">
                  <c:v>555</c:v>
                </c:pt>
                <c:pt idx="112" formatCode="General">
                  <c:v>560</c:v>
                </c:pt>
                <c:pt idx="113" formatCode="General">
                  <c:v>565</c:v>
                </c:pt>
                <c:pt idx="114" formatCode="General">
                  <c:v>570</c:v>
                </c:pt>
                <c:pt idx="115" formatCode="General">
                  <c:v>575</c:v>
                </c:pt>
                <c:pt idx="116" formatCode="General">
                  <c:v>580</c:v>
                </c:pt>
                <c:pt idx="117" formatCode="General">
                  <c:v>585</c:v>
                </c:pt>
                <c:pt idx="118" formatCode="General">
                  <c:v>590</c:v>
                </c:pt>
                <c:pt idx="119" formatCode="General">
                  <c:v>595</c:v>
                </c:pt>
                <c:pt idx="120" formatCode="General">
                  <c:v>600</c:v>
                </c:pt>
                <c:pt idx="121" formatCode="General">
                  <c:v>605</c:v>
                </c:pt>
                <c:pt idx="122" formatCode="General">
                  <c:v>610</c:v>
                </c:pt>
                <c:pt idx="123" formatCode="General">
                  <c:v>615</c:v>
                </c:pt>
                <c:pt idx="124" formatCode="General">
                  <c:v>620</c:v>
                </c:pt>
                <c:pt idx="125" formatCode="General">
                  <c:v>625</c:v>
                </c:pt>
                <c:pt idx="126" formatCode="General">
                  <c:v>630</c:v>
                </c:pt>
                <c:pt idx="127" formatCode="General">
                  <c:v>635</c:v>
                </c:pt>
                <c:pt idx="128" formatCode="General">
                  <c:v>640</c:v>
                </c:pt>
                <c:pt idx="129" formatCode="General">
                  <c:v>645</c:v>
                </c:pt>
                <c:pt idx="130" formatCode="General">
                  <c:v>650</c:v>
                </c:pt>
                <c:pt idx="131" formatCode="General">
                  <c:v>655</c:v>
                </c:pt>
                <c:pt idx="132" formatCode="General">
                  <c:v>660</c:v>
                </c:pt>
                <c:pt idx="133" formatCode="General">
                  <c:v>665</c:v>
                </c:pt>
                <c:pt idx="134" formatCode="General">
                  <c:v>670</c:v>
                </c:pt>
                <c:pt idx="135" formatCode="General">
                  <c:v>675</c:v>
                </c:pt>
                <c:pt idx="136" formatCode="General">
                  <c:v>680</c:v>
                </c:pt>
                <c:pt idx="137" formatCode="General">
                  <c:v>685</c:v>
                </c:pt>
                <c:pt idx="138" formatCode="General">
                  <c:v>690</c:v>
                </c:pt>
                <c:pt idx="139" formatCode="General">
                  <c:v>695</c:v>
                </c:pt>
                <c:pt idx="140" formatCode="General">
                  <c:v>700</c:v>
                </c:pt>
                <c:pt idx="141" formatCode="General">
                  <c:v>705</c:v>
                </c:pt>
                <c:pt idx="142" formatCode="General">
                  <c:v>710</c:v>
                </c:pt>
                <c:pt idx="143" formatCode="General">
                  <c:v>715</c:v>
                </c:pt>
                <c:pt idx="144" formatCode="General">
                  <c:v>720</c:v>
                </c:pt>
                <c:pt idx="145" formatCode="General">
                  <c:v>725</c:v>
                </c:pt>
                <c:pt idx="146" formatCode="General">
                  <c:v>730</c:v>
                </c:pt>
                <c:pt idx="147" formatCode="General">
                  <c:v>735</c:v>
                </c:pt>
                <c:pt idx="148" formatCode="General">
                  <c:v>740</c:v>
                </c:pt>
                <c:pt idx="149" formatCode="General">
                  <c:v>745</c:v>
                </c:pt>
                <c:pt idx="150" formatCode="General">
                  <c:v>750</c:v>
                </c:pt>
                <c:pt idx="151" formatCode="General">
                  <c:v>755</c:v>
                </c:pt>
                <c:pt idx="152" formatCode="General">
                  <c:v>760</c:v>
                </c:pt>
                <c:pt idx="153" formatCode="General">
                  <c:v>765</c:v>
                </c:pt>
                <c:pt idx="154" formatCode="General">
                  <c:v>770</c:v>
                </c:pt>
                <c:pt idx="155" formatCode="General">
                  <c:v>775</c:v>
                </c:pt>
                <c:pt idx="156" formatCode="General">
                  <c:v>780</c:v>
                </c:pt>
                <c:pt idx="157" formatCode="General">
                  <c:v>785</c:v>
                </c:pt>
                <c:pt idx="158" formatCode="General">
                  <c:v>790</c:v>
                </c:pt>
                <c:pt idx="159" formatCode="General">
                  <c:v>795</c:v>
                </c:pt>
                <c:pt idx="160" formatCode="General">
                  <c:v>800</c:v>
                </c:pt>
                <c:pt idx="161" formatCode="General">
                  <c:v>805</c:v>
                </c:pt>
                <c:pt idx="162" formatCode="General">
                  <c:v>810</c:v>
                </c:pt>
                <c:pt idx="163" formatCode="General">
                  <c:v>815</c:v>
                </c:pt>
                <c:pt idx="164" formatCode="General">
                  <c:v>820</c:v>
                </c:pt>
                <c:pt idx="165" formatCode="General">
                  <c:v>825</c:v>
                </c:pt>
                <c:pt idx="166" formatCode="General">
                  <c:v>830</c:v>
                </c:pt>
                <c:pt idx="167" formatCode="General">
                  <c:v>835</c:v>
                </c:pt>
                <c:pt idx="168" formatCode="General">
                  <c:v>840</c:v>
                </c:pt>
                <c:pt idx="169" formatCode="General">
                  <c:v>845</c:v>
                </c:pt>
                <c:pt idx="170" formatCode="General">
                  <c:v>850</c:v>
                </c:pt>
                <c:pt idx="171" formatCode="General">
                  <c:v>855</c:v>
                </c:pt>
                <c:pt idx="172" formatCode="General">
                  <c:v>860</c:v>
                </c:pt>
                <c:pt idx="173" formatCode="General">
                  <c:v>865</c:v>
                </c:pt>
                <c:pt idx="174" formatCode="General">
                  <c:v>870</c:v>
                </c:pt>
                <c:pt idx="175" formatCode="General">
                  <c:v>875</c:v>
                </c:pt>
                <c:pt idx="176" formatCode="General">
                  <c:v>880</c:v>
                </c:pt>
                <c:pt idx="177" formatCode="General">
                  <c:v>885</c:v>
                </c:pt>
                <c:pt idx="178" formatCode="General">
                  <c:v>890</c:v>
                </c:pt>
                <c:pt idx="179" formatCode="General">
                  <c:v>895</c:v>
                </c:pt>
                <c:pt idx="180" formatCode="General">
                  <c:v>900</c:v>
                </c:pt>
                <c:pt idx="181" formatCode="General">
                  <c:v>905</c:v>
                </c:pt>
                <c:pt idx="182" formatCode="General">
                  <c:v>910</c:v>
                </c:pt>
                <c:pt idx="183" formatCode="General">
                  <c:v>915</c:v>
                </c:pt>
                <c:pt idx="184" formatCode="General">
                  <c:v>920</c:v>
                </c:pt>
                <c:pt idx="185" formatCode="General">
                  <c:v>925</c:v>
                </c:pt>
                <c:pt idx="186" formatCode="General">
                  <c:v>930</c:v>
                </c:pt>
                <c:pt idx="187" formatCode="General">
                  <c:v>935</c:v>
                </c:pt>
                <c:pt idx="188" formatCode="General">
                  <c:v>940</c:v>
                </c:pt>
                <c:pt idx="189" formatCode="General">
                  <c:v>945</c:v>
                </c:pt>
                <c:pt idx="190" formatCode="General">
                  <c:v>950</c:v>
                </c:pt>
                <c:pt idx="191" formatCode="General">
                  <c:v>955</c:v>
                </c:pt>
                <c:pt idx="192" formatCode="General">
                  <c:v>960</c:v>
                </c:pt>
                <c:pt idx="193" formatCode="General">
                  <c:v>965</c:v>
                </c:pt>
                <c:pt idx="194" formatCode="General">
                  <c:v>970</c:v>
                </c:pt>
                <c:pt idx="195" formatCode="General">
                  <c:v>975</c:v>
                </c:pt>
                <c:pt idx="196" formatCode="General">
                  <c:v>980</c:v>
                </c:pt>
                <c:pt idx="197" formatCode="General">
                  <c:v>985</c:v>
                </c:pt>
                <c:pt idx="198" formatCode="General">
                  <c:v>990</c:v>
                </c:pt>
                <c:pt idx="199" formatCode="General">
                  <c:v>995</c:v>
                </c:pt>
              </c:numCache>
            </c:numRef>
          </c:xVal>
          <c:yVal>
            <c:numRef>
              <c:f>Feuil1!$B$3:$B$202</c:f>
              <c:numCache>
                <c:formatCode>0.00</c:formatCode>
                <c:ptCount val="200"/>
                <c:pt idx="0">
                  <c:v>3.63</c:v>
                </c:pt>
                <c:pt idx="1">
                  <c:v>3.5710000000000002</c:v>
                </c:pt>
                <c:pt idx="2">
                  <c:v>3.5110000000000001</c:v>
                </c:pt>
                <c:pt idx="3">
                  <c:v>3.464</c:v>
                </c:pt>
                <c:pt idx="4">
                  <c:v>3.4670000000000001</c:v>
                </c:pt>
                <c:pt idx="5">
                  <c:v>3.4550000000000001</c:v>
                </c:pt>
                <c:pt idx="6">
                  <c:v>3.4519999999999991</c:v>
                </c:pt>
                <c:pt idx="7">
                  <c:v>3.4329999999999998</c:v>
                </c:pt>
                <c:pt idx="8">
                  <c:v>3.411</c:v>
                </c:pt>
                <c:pt idx="9">
                  <c:v>3.4039999999999999</c:v>
                </c:pt>
                <c:pt idx="10">
                  <c:v>3.3820000000000001</c:v>
                </c:pt>
                <c:pt idx="11">
                  <c:v>3.3780000000000001</c:v>
                </c:pt>
                <c:pt idx="12">
                  <c:v>3.3370000000000002</c:v>
                </c:pt>
                <c:pt idx="13">
                  <c:v>3.3290000000000002</c:v>
                </c:pt>
                <c:pt idx="14">
                  <c:v>3.3050000000000002</c:v>
                </c:pt>
                <c:pt idx="15">
                  <c:v>3.3050000000000002</c:v>
                </c:pt>
                <c:pt idx="16">
                  <c:v>3.3149999999999991</c:v>
                </c:pt>
                <c:pt idx="17">
                  <c:v>3.306</c:v>
                </c:pt>
                <c:pt idx="18">
                  <c:v>3.3029999999999999</c:v>
                </c:pt>
                <c:pt idx="19">
                  <c:v>3.2869999999999999</c:v>
                </c:pt>
                <c:pt idx="20">
                  <c:v>3.306</c:v>
                </c:pt>
                <c:pt idx="21">
                  <c:v>3.2890000000000001</c:v>
                </c:pt>
                <c:pt idx="22">
                  <c:v>3.2949999999999999</c:v>
                </c:pt>
                <c:pt idx="23">
                  <c:v>3.2890000000000001</c:v>
                </c:pt>
                <c:pt idx="24">
                  <c:v>3.2469999999999999</c:v>
                </c:pt>
                <c:pt idx="25">
                  <c:v>6.577</c:v>
                </c:pt>
                <c:pt idx="26">
                  <c:v>7.0869999999999997</c:v>
                </c:pt>
                <c:pt idx="27">
                  <c:v>7.0090000000000003</c:v>
                </c:pt>
                <c:pt idx="28">
                  <c:v>6.9059999999999997</c:v>
                </c:pt>
                <c:pt idx="29">
                  <c:v>6.8449999999999998</c:v>
                </c:pt>
                <c:pt idx="30">
                  <c:v>6.7919999999999998</c:v>
                </c:pt>
                <c:pt idx="31">
                  <c:v>6.7219999999999986</c:v>
                </c:pt>
                <c:pt idx="32" formatCode="General">
                  <c:v>6.6099999999999977</c:v>
                </c:pt>
                <c:pt idx="33" formatCode="General">
                  <c:v>6.5569999999999986</c:v>
                </c:pt>
                <c:pt idx="34" formatCode="General">
                  <c:v>6.5010000000000003</c:v>
                </c:pt>
                <c:pt idx="35" formatCode="General">
                  <c:v>6.4639999999999986</c:v>
                </c:pt>
                <c:pt idx="36" formatCode="General">
                  <c:v>6.4119999999999999</c:v>
                </c:pt>
                <c:pt idx="37" formatCode="General">
                  <c:v>6.3360000000000003</c:v>
                </c:pt>
                <c:pt idx="38" formatCode="General">
                  <c:v>6.29</c:v>
                </c:pt>
                <c:pt idx="39" formatCode="General">
                  <c:v>6.1879999999999997</c:v>
                </c:pt>
                <c:pt idx="40" formatCode="General">
                  <c:v>6.1379999999999999</c:v>
                </c:pt>
                <c:pt idx="41" formatCode="General">
                  <c:v>6.0810000000000004</c:v>
                </c:pt>
                <c:pt idx="42" formatCode="General">
                  <c:v>6.0269999999999984</c:v>
                </c:pt>
                <c:pt idx="43" formatCode="General">
                  <c:v>5.9589999999999996</c:v>
                </c:pt>
                <c:pt idx="44" formatCode="General">
                  <c:v>5.9269999999999996</c:v>
                </c:pt>
                <c:pt idx="45" formatCode="General">
                  <c:v>5.9050000000000002</c:v>
                </c:pt>
                <c:pt idx="46" formatCode="General">
                  <c:v>5.81</c:v>
                </c:pt>
                <c:pt idx="47" formatCode="General">
                  <c:v>7.2949999999999999</c:v>
                </c:pt>
                <c:pt idx="48" formatCode="General">
                  <c:v>8.7140000000000004</c:v>
                </c:pt>
                <c:pt idx="49" formatCode="General">
                  <c:v>8.5760000000000005</c:v>
                </c:pt>
                <c:pt idx="50" formatCode="General">
                  <c:v>8.484</c:v>
                </c:pt>
                <c:pt idx="51" formatCode="General">
                  <c:v>8.3849999999999998</c:v>
                </c:pt>
                <c:pt idx="52" formatCode="General">
                  <c:v>8.2910000000000004</c:v>
                </c:pt>
                <c:pt idx="53" formatCode="General">
                  <c:v>8.2059999999999995</c:v>
                </c:pt>
                <c:pt idx="54" formatCode="General">
                  <c:v>8.1110000000000007</c:v>
                </c:pt>
                <c:pt idx="55" formatCode="General">
                  <c:v>8.0060000000000002</c:v>
                </c:pt>
                <c:pt idx="56" formatCode="General">
                  <c:v>7.931</c:v>
                </c:pt>
                <c:pt idx="57" formatCode="General">
                  <c:v>7.859</c:v>
                </c:pt>
                <c:pt idx="58" formatCode="General">
                  <c:v>7.7830000000000004</c:v>
                </c:pt>
                <c:pt idx="59" formatCode="General">
                  <c:v>7.6769999999999996</c:v>
                </c:pt>
                <c:pt idx="60" formatCode="General">
                  <c:v>7.6209999999999978</c:v>
                </c:pt>
                <c:pt idx="61" formatCode="General">
                  <c:v>7.5239999999999982</c:v>
                </c:pt>
                <c:pt idx="62" formatCode="General">
                  <c:v>7.444</c:v>
                </c:pt>
                <c:pt idx="63" formatCode="General">
                  <c:v>7.3449999999999998</c:v>
                </c:pt>
                <c:pt idx="64" formatCode="General">
                  <c:v>7.27</c:v>
                </c:pt>
                <c:pt idx="65" formatCode="General">
                  <c:v>7.22</c:v>
                </c:pt>
                <c:pt idx="66" formatCode="General">
                  <c:v>9.5730000000000004</c:v>
                </c:pt>
                <c:pt idx="67" formatCode="General">
                  <c:v>9.7940000000000005</c:v>
                </c:pt>
                <c:pt idx="68" formatCode="General">
                  <c:v>9.6999999999999993</c:v>
                </c:pt>
                <c:pt idx="69" formatCode="General">
                  <c:v>9.577</c:v>
                </c:pt>
                <c:pt idx="70" formatCode="General">
                  <c:v>9.4749999999999996</c:v>
                </c:pt>
                <c:pt idx="71" formatCode="General">
                  <c:v>9.36</c:v>
                </c:pt>
                <c:pt idx="72" formatCode="General">
                  <c:v>9.2720000000000002</c:v>
                </c:pt>
                <c:pt idx="73" formatCode="General">
                  <c:v>9.1590000000000007</c:v>
                </c:pt>
                <c:pt idx="74" formatCode="General">
                  <c:v>9.0370000000000008</c:v>
                </c:pt>
                <c:pt idx="75" formatCode="General">
                  <c:v>8.9510000000000005</c:v>
                </c:pt>
                <c:pt idx="76" formatCode="General">
                  <c:v>8.8829999999999991</c:v>
                </c:pt>
                <c:pt idx="77" formatCode="General">
                  <c:v>8.7789999999999999</c:v>
                </c:pt>
                <c:pt idx="78" formatCode="General">
                  <c:v>8.6690000000000005</c:v>
                </c:pt>
                <c:pt idx="79" formatCode="General">
                  <c:v>8.6010000000000009</c:v>
                </c:pt>
                <c:pt idx="80" formatCode="General">
                  <c:v>8.5210000000000008</c:v>
                </c:pt>
                <c:pt idx="81" formatCode="General">
                  <c:v>8.4139999999999997</c:v>
                </c:pt>
                <c:pt idx="82" formatCode="General">
                  <c:v>8.359</c:v>
                </c:pt>
                <c:pt idx="83" formatCode="General">
                  <c:v>8.2590000000000003</c:v>
                </c:pt>
                <c:pt idx="84" formatCode="General">
                  <c:v>8.2880000000000003</c:v>
                </c:pt>
                <c:pt idx="85" formatCode="General">
                  <c:v>10.58</c:v>
                </c:pt>
                <c:pt idx="86" formatCode="General">
                  <c:v>10.52</c:v>
                </c:pt>
                <c:pt idx="87" formatCode="General">
                  <c:v>10.43</c:v>
                </c:pt>
                <c:pt idx="88" formatCode="General">
                  <c:v>10.31</c:v>
                </c:pt>
                <c:pt idx="89" formatCode="General">
                  <c:v>10.25</c:v>
                </c:pt>
                <c:pt idx="90" formatCode="General">
                  <c:v>10.130000000000001</c:v>
                </c:pt>
                <c:pt idx="91" formatCode="General">
                  <c:v>10.06</c:v>
                </c:pt>
                <c:pt idx="92" formatCode="General">
                  <c:v>9.9809999999999999</c:v>
                </c:pt>
                <c:pt idx="93" formatCode="General">
                  <c:v>9.8580000000000005</c:v>
                </c:pt>
                <c:pt idx="94" formatCode="General">
                  <c:v>9.7880000000000003</c:v>
                </c:pt>
                <c:pt idx="95" formatCode="General">
                  <c:v>9.7230000000000008</c:v>
                </c:pt>
                <c:pt idx="96" formatCode="General">
                  <c:v>9.6419999999999995</c:v>
                </c:pt>
                <c:pt idx="97" formatCode="General">
                  <c:v>9.5760000000000005</c:v>
                </c:pt>
                <c:pt idx="98" formatCode="General">
                  <c:v>9.49</c:v>
                </c:pt>
                <c:pt idx="99" formatCode="General">
                  <c:v>9.44</c:v>
                </c:pt>
                <c:pt idx="100" formatCode="General">
                  <c:v>9.39</c:v>
                </c:pt>
                <c:pt idx="101" formatCode="General">
                  <c:v>9.3309999999999995</c:v>
                </c:pt>
                <c:pt idx="102" formatCode="General">
                  <c:v>9.2810000000000006</c:v>
                </c:pt>
                <c:pt idx="103" formatCode="General">
                  <c:v>9.7159999999999993</c:v>
                </c:pt>
                <c:pt idx="104" formatCode="General">
                  <c:v>11.49</c:v>
                </c:pt>
                <c:pt idx="105" formatCode="General">
                  <c:v>11.39</c:v>
                </c:pt>
                <c:pt idx="106" formatCode="General">
                  <c:v>11.31</c:v>
                </c:pt>
                <c:pt idx="107" formatCode="General">
                  <c:v>11.23</c:v>
                </c:pt>
                <c:pt idx="108" formatCode="General">
                  <c:v>11.11</c:v>
                </c:pt>
                <c:pt idx="109" formatCode="General">
                  <c:v>11.05</c:v>
                </c:pt>
                <c:pt idx="110" formatCode="General">
                  <c:v>11.02</c:v>
                </c:pt>
                <c:pt idx="111" formatCode="General">
                  <c:v>10.96</c:v>
                </c:pt>
                <c:pt idx="112" formatCode="General">
                  <c:v>10.91</c:v>
                </c:pt>
                <c:pt idx="113" formatCode="General">
                  <c:v>10.88</c:v>
                </c:pt>
                <c:pt idx="114" formatCode="General">
                  <c:v>10.86</c:v>
                </c:pt>
                <c:pt idx="115" formatCode="General">
                  <c:v>10.79</c:v>
                </c:pt>
                <c:pt idx="116" formatCode="General">
                  <c:v>10.78</c:v>
                </c:pt>
                <c:pt idx="117" formatCode="General">
                  <c:v>10.74</c:v>
                </c:pt>
                <c:pt idx="118" formatCode="General">
                  <c:v>10.76</c:v>
                </c:pt>
                <c:pt idx="119" formatCode="General">
                  <c:v>10.76</c:v>
                </c:pt>
                <c:pt idx="120" formatCode="General">
                  <c:v>10.72</c:v>
                </c:pt>
                <c:pt idx="121" formatCode="General">
                  <c:v>10.72</c:v>
                </c:pt>
                <c:pt idx="122" formatCode="General">
                  <c:v>11.31</c:v>
                </c:pt>
                <c:pt idx="123" formatCode="General">
                  <c:v>12.65</c:v>
                </c:pt>
                <c:pt idx="124" formatCode="General">
                  <c:v>12.63</c:v>
                </c:pt>
                <c:pt idx="125" formatCode="General">
                  <c:v>12.58</c:v>
                </c:pt>
                <c:pt idx="126" formatCode="General">
                  <c:v>12.55</c:v>
                </c:pt>
                <c:pt idx="127" formatCode="General">
                  <c:v>12.51</c:v>
                </c:pt>
                <c:pt idx="128" formatCode="General">
                  <c:v>12.48</c:v>
                </c:pt>
                <c:pt idx="129" formatCode="General">
                  <c:v>12.49</c:v>
                </c:pt>
                <c:pt idx="130" formatCode="General">
                  <c:v>12.5</c:v>
                </c:pt>
                <c:pt idx="131" formatCode="General">
                  <c:v>12.5</c:v>
                </c:pt>
                <c:pt idx="132" formatCode="General">
                  <c:v>12.48</c:v>
                </c:pt>
                <c:pt idx="133" formatCode="General">
                  <c:v>12.47</c:v>
                </c:pt>
                <c:pt idx="134" formatCode="General">
                  <c:v>12.47</c:v>
                </c:pt>
                <c:pt idx="135" formatCode="General">
                  <c:v>12.47</c:v>
                </c:pt>
                <c:pt idx="136" formatCode="General">
                  <c:v>12.48</c:v>
                </c:pt>
                <c:pt idx="137" formatCode="General">
                  <c:v>12.46</c:v>
                </c:pt>
                <c:pt idx="138" formatCode="General">
                  <c:v>12.44</c:v>
                </c:pt>
                <c:pt idx="139" formatCode="General">
                  <c:v>12.47</c:v>
                </c:pt>
                <c:pt idx="140" formatCode="General">
                  <c:v>12.47</c:v>
                </c:pt>
                <c:pt idx="141" formatCode="General">
                  <c:v>12.5</c:v>
                </c:pt>
                <c:pt idx="142" formatCode="General">
                  <c:v>12.52</c:v>
                </c:pt>
                <c:pt idx="143" formatCode="General">
                  <c:v>12.52</c:v>
                </c:pt>
                <c:pt idx="144" formatCode="General">
                  <c:v>12.54</c:v>
                </c:pt>
                <c:pt idx="145" formatCode="General">
                  <c:v>12.58</c:v>
                </c:pt>
                <c:pt idx="146" formatCode="General">
                  <c:v>12.6</c:v>
                </c:pt>
                <c:pt idx="147" formatCode="General">
                  <c:v>12.62</c:v>
                </c:pt>
                <c:pt idx="148" formatCode="General">
                  <c:v>12.68</c:v>
                </c:pt>
                <c:pt idx="149" formatCode="General">
                  <c:v>12.69</c:v>
                </c:pt>
                <c:pt idx="150" formatCode="General">
                  <c:v>12.7</c:v>
                </c:pt>
                <c:pt idx="151" formatCode="General">
                  <c:v>12.74</c:v>
                </c:pt>
                <c:pt idx="152" formatCode="General">
                  <c:v>12.76</c:v>
                </c:pt>
                <c:pt idx="153" formatCode="General">
                  <c:v>12.81</c:v>
                </c:pt>
                <c:pt idx="154" formatCode="General">
                  <c:v>12.86</c:v>
                </c:pt>
                <c:pt idx="155" formatCode="General">
                  <c:v>12.89</c:v>
                </c:pt>
                <c:pt idx="156" formatCode="General">
                  <c:v>12.91</c:v>
                </c:pt>
                <c:pt idx="157" formatCode="General">
                  <c:v>12.99</c:v>
                </c:pt>
                <c:pt idx="158" formatCode="General">
                  <c:v>13</c:v>
                </c:pt>
                <c:pt idx="159" formatCode="General">
                  <c:v>12.99</c:v>
                </c:pt>
                <c:pt idx="160" formatCode="General">
                  <c:v>13.05</c:v>
                </c:pt>
                <c:pt idx="161" formatCode="General">
                  <c:v>13.09</c:v>
                </c:pt>
                <c:pt idx="162" formatCode="General">
                  <c:v>13.14</c:v>
                </c:pt>
                <c:pt idx="163" formatCode="General">
                  <c:v>13.18</c:v>
                </c:pt>
                <c:pt idx="164" formatCode="General">
                  <c:v>13.24</c:v>
                </c:pt>
                <c:pt idx="165" formatCode="General">
                  <c:v>13.26</c:v>
                </c:pt>
                <c:pt idx="166" formatCode="General">
                  <c:v>13.28</c:v>
                </c:pt>
                <c:pt idx="167" formatCode="General">
                  <c:v>13.34</c:v>
                </c:pt>
                <c:pt idx="168" formatCode="General">
                  <c:v>13.35</c:v>
                </c:pt>
                <c:pt idx="169" formatCode="General">
                  <c:v>13.4</c:v>
                </c:pt>
                <c:pt idx="170" formatCode="General">
                  <c:v>13.46</c:v>
                </c:pt>
                <c:pt idx="171" formatCode="General">
                  <c:v>13.49</c:v>
                </c:pt>
                <c:pt idx="172" formatCode="General">
                  <c:v>13.52</c:v>
                </c:pt>
                <c:pt idx="173" formatCode="General">
                  <c:v>13.57</c:v>
                </c:pt>
                <c:pt idx="174" formatCode="General">
                  <c:v>13.62</c:v>
                </c:pt>
                <c:pt idx="175" formatCode="General">
                  <c:v>13.66</c:v>
                </c:pt>
                <c:pt idx="176" formatCode="General">
                  <c:v>13.69</c:v>
                </c:pt>
                <c:pt idx="177" formatCode="General">
                  <c:v>13.73</c:v>
                </c:pt>
                <c:pt idx="178" formatCode="General">
                  <c:v>13.76</c:v>
                </c:pt>
                <c:pt idx="179" formatCode="General">
                  <c:v>13.82</c:v>
                </c:pt>
                <c:pt idx="180" formatCode="General">
                  <c:v>13.86</c:v>
                </c:pt>
                <c:pt idx="181" formatCode="General">
                  <c:v>13.91</c:v>
                </c:pt>
                <c:pt idx="182" formatCode="General">
                  <c:v>13.92</c:v>
                </c:pt>
                <c:pt idx="183" formatCode="General">
                  <c:v>13.94</c:v>
                </c:pt>
                <c:pt idx="184" formatCode="General">
                  <c:v>14.02</c:v>
                </c:pt>
                <c:pt idx="185" formatCode="General">
                  <c:v>14.06</c:v>
                </c:pt>
                <c:pt idx="186" formatCode="General">
                  <c:v>14.11</c:v>
                </c:pt>
                <c:pt idx="187" formatCode="General">
                  <c:v>14.15</c:v>
                </c:pt>
                <c:pt idx="188" formatCode="General">
                  <c:v>14.19</c:v>
                </c:pt>
                <c:pt idx="189" formatCode="General">
                  <c:v>14.22</c:v>
                </c:pt>
                <c:pt idx="190" formatCode="General">
                  <c:v>14.29</c:v>
                </c:pt>
                <c:pt idx="191" formatCode="General">
                  <c:v>14.31</c:v>
                </c:pt>
                <c:pt idx="192" formatCode="General">
                  <c:v>14.34</c:v>
                </c:pt>
                <c:pt idx="193" formatCode="General">
                  <c:v>14.4</c:v>
                </c:pt>
                <c:pt idx="194" formatCode="General">
                  <c:v>14.42</c:v>
                </c:pt>
                <c:pt idx="195" formatCode="General">
                  <c:v>14.4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51C-FD48-BF37-2CF52A18E8C3}"/>
            </c:ext>
          </c:extLst>
        </c:ser>
        <c:ser>
          <c:idx val="1"/>
          <c:order val="1"/>
          <c:tx>
            <c:strRef>
              <c:f>Feuil1!$C$2</c:f>
              <c:strCache>
                <c:ptCount val="1"/>
              </c:strCache>
            </c:strRef>
          </c:tx>
          <c:spPr>
            <a:ln w="28575" cap="rnd" cmpd="sng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Feuil1!$A$3:$A$202</c:f>
              <c:numCache>
                <c:formatCode>0.00</c:formatCode>
                <c:ptCount val="200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  <c:pt idx="25">
                  <c:v>125</c:v>
                </c:pt>
                <c:pt idx="26">
                  <c:v>130</c:v>
                </c:pt>
                <c:pt idx="27">
                  <c:v>135</c:v>
                </c:pt>
                <c:pt idx="28">
                  <c:v>140</c:v>
                </c:pt>
                <c:pt idx="29">
                  <c:v>145</c:v>
                </c:pt>
                <c:pt idx="30">
                  <c:v>150</c:v>
                </c:pt>
                <c:pt idx="31">
                  <c:v>155</c:v>
                </c:pt>
                <c:pt idx="32" formatCode="General">
                  <c:v>160</c:v>
                </c:pt>
                <c:pt idx="33" formatCode="General">
                  <c:v>165</c:v>
                </c:pt>
                <c:pt idx="34" formatCode="General">
                  <c:v>170</c:v>
                </c:pt>
                <c:pt idx="35" formatCode="General">
                  <c:v>175</c:v>
                </c:pt>
                <c:pt idx="36" formatCode="General">
                  <c:v>180</c:v>
                </c:pt>
                <c:pt idx="37" formatCode="General">
                  <c:v>185</c:v>
                </c:pt>
                <c:pt idx="38" formatCode="General">
                  <c:v>190</c:v>
                </c:pt>
                <c:pt idx="39" formatCode="General">
                  <c:v>195</c:v>
                </c:pt>
                <c:pt idx="40" formatCode="General">
                  <c:v>200</c:v>
                </c:pt>
                <c:pt idx="41" formatCode="General">
                  <c:v>205</c:v>
                </c:pt>
                <c:pt idx="42" formatCode="General">
                  <c:v>210</c:v>
                </c:pt>
                <c:pt idx="43" formatCode="General">
                  <c:v>215</c:v>
                </c:pt>
                <c:pt idx="44" formatCode="General">
                  <c:v>220</c:v>
                </c:pt>
                <c:pt idx="45" formatCode="General">
                  <c:v>225</c:v>
                </c:pt>
                <c:pt idx="46" formatCode="General">
                  <c:v>230</c:v>
                </c:pt>
                <c:pt idx="47" formatCode="General">
                  <c:v>235</c:v>
                </c:pt>
                <c:pt idx="48" formatCode="General">
                  <c:v>240</c:v>
                </c:pt>
                <c:pt idx="49" formatCode="General">
                  <c:v>245</c:v>
                </c:pt>
                <c:pt idx="50" formatCode="General">
                  <c:v>250</c:v>
                </c:pt>
                <c:pt idx="51" formatCode="General">
                  <c:v>255</c:v>
                </c:pt>
                <c:pt idx="52" formatCode="General">
                  <c:v>260</c:v>
                </c:pt>
                <c:pt idx="53" formatCode="General">
                  <c:v>265</c:v>
                </c:pt>
                <c:pt idx="54" formatCode="General">
                  <c:v>270</c:v>
                </c:pt>
                <c:pt idx="55" formatCode="General">
                  <c:v>275</c:v>
                </c:pt>
                <c:pt idx="56" formatCode="General">
                  <c:v>280</c:v>
                </c:pt>
                <c:pt idx="57" formatCode="General">
                  <c:v>285</c:v>
                </c:pt>
                <c:pt idx="58" formatCode="General">
                  <c:v>290</c:v>
                </c:pt>
                <c:pt idx="59" formatCode="General">
                  <c:v>295</c:v>
                </c:pt>
                <c:pt idx="60" formatCode="General">
                  <c:v>300</c:v>
                </c:pt>
                <c:pt idx="61" formatCode="General">
                  <c:v>305</c:v>
                </c:pt>
                <c:pt idx="62" formatCode="General">
                  <c:v>310</c:v>
                </c:pt>
                <c:pt idx="63" formatCode="General">
                  <c:v>315</c:v>
                </c:pt>
                <c:pt idx="64" formatCode="General">
                  <c:v>320</c:v>
                </c:pt>
                <c:pt idx="65" formatCode="General">
                  <c:v>325</c:v>
                </c:pt>
                <c:pt idx="66" formatCode="General">
                  <c:v>330</c:v>
                </c:pt>
                <c:pt idx="67" formatCode="General">
                  <c:v>335</c:v>
                </c:pt>
                <c:pt idx="68" formatCode="General">
                  <c:v>340</c:v>
                </c:pt>
                <c:pt idx="69" formatCode="General">
                  <c:v>345</c:v>
                </c:pt>
                <c:pt idx="70" formatCode="General">
                  <c:v>350</c:v>
                </c:pt>
                <c:pt idx="71" formatCode="General">
                  <c:v>355</c:v>
                </c:pt>
                <c:pt idx="72" formatCode="General">
                  <c:v>360</c:v>
                </c:pt>
                <c:pt idx="73" formatCode="General">
                  <c:v>365</c:v>
                </c:pt>
                <c:pt idx="74" formatCode="General">
                  <c:v>370</c:v>
                </c:pt>
                <c:pt idx="75" formatCode="General">
                  <c:v>375</c:v>
                </c:pt>
                <c:pt idx="76" formatCode="General">
                  <c:v>380</c:v>
                </c:pt>
                <c:pt idx="77" formatCode="General">
                  <c:v>385</c:v>
                </c:pt>
                <c:pt idx="78" formatCode="General">
                  <c:v>390</c:v>
                </c:pt>
                <c:pt idx="79" formatCode="General">
                  <c:v>395</c:v>
                </c:pt>
                <c:pt idx="80" formatCode="General">
                  <c:v>400</c:v>
                </c:pt>
                <c:pt idx="81" formatCode="General">
                  <c:v>405</c:v>
                </c:pt>
                <c:pt idx="82" formatCode="General">
                  <c:v>410</c:v>
                </c:pt>
                <c:pt idx="83" formatCode="General">
                  <c:v>415</c:v>
                </c:pt>
                <c:pt idx="84" formatCode="General">
                  <c:v>420</c:v>
                </c:pt>
                <c:pt idx="85" formatCode="General">
                  <c:v>425</c:v>
                </c:pt>
                <c:pt idx="86" formatCode="General">
                  <c:v>430</c:v>
                </c:pt>
                <c:pt idx="87" formatCode="General">
                  <c:v>435</c:v>
                </c:pt>
                <c:pt idx="88" formatCode="General">
                  <c:v>440</c:v>
                </c:pt>
                <c:pt idx="89" formatCode="General">
                  <c:v>445</c:v>
                </c:pt>
                <c:pt idx="90" formatCode="General">
                  <c:v>450</c:v>
                </c:pt>
                <c:pt idx="91" formatCode="General">
                  <c:v>455</c:v>
                </c:pt>
                <c:pt idx="92" formatCode="General">
                  <c:v>460</c:v>
                </c:pt>
                <c:pt idx="93" formatCode="General">
                  <c:v>465</c:v>
                </c:pt>
                <c:pt idx="94" formatCode="General">
                  <c:v>470</c:v>
                </c:pt>
                <c:pt idx="95" formatCode="General">
                  <c:v>475</c:v>
                </c:pt>
                <c:pt idx="96" formatCode="General">
                  <c:v>480</c:v>
                </c:pt>
                <c:pt idx="97" formatCode="General">
                  <c:v>485</c:v>
                </c:pt>
                <c:pt idx="98" formatCode="General">
                  <c:v>490</c:v>
                </c:pt>
                <c:pt idx="99" formatCode="General">
                  <c:v>495</c:v>
                </c:pt>
                <c:pt idx="100" formatCode="General">
                  <c:v>500</c:v>
                </c:pt>
                <c:pt idx="101" formatCode="General">
                  <c:v>505</c:v>
                </c:pt>
                <c:pt idx="102" formatCode="General">
                  <c:v>510</c:v>
                </c:pt>
                <c:pt idx="103" formatCode="General">
                  <c:v>515</c:v>
                </c:pt>
                <c:pt idx="104" formatCode="General">
                  <c:v>520</c:v>
                </c:pt>
                <c:pt idx="105" formatCode="General">
                  <c:v>525</c:v>
                </c:pt>
                <c:pt idx="106" formatCode="General">
                  <c:v>530</c:v>
                </c:pt>
                <c:pt idx="107" formatCode="General">
                  <c:v>535</c:v>
                </c:pt>
                <c:pt idx="108" formatCode="General">
                  <c:v>540</c:v>
                </c:pt>
                <c:pt idx="109" formatCode="General">
                  <c:v>545</c:v>
                </c:pt>
                <c:pt idx="110" formatCode="General">
                  <c:v>550</c:v>
                </c:pt>
                <c:pt idx="111" formatCode="General">
                  <c:v>555</c:v>
                </c:pt>
                <c:pt idx="112" formatCode="General">
                  <c:v>560</c:v>
                </c:pt>
                <c:pt idx="113" formatCode="General">
                  <c:v>565</c:v>
                </c:pt>
                <c:pt idx="114" formatCode="General">
                  <c:v>570</c:v>
                </c:pt>
                <c:pt idx="115" formatCode="General">
                  <c:v>575</c:v>
                </c:pt>
                <c:pt idx="116" formatCode="General">
                  <c:v>580</c:v>
                </c:pt>
                <c:pt idx="117" formatCode="General">
                  <c:v>585</c:v>
                </c:pt>
                <c:pt idx="118" formatCode="General">
                  <c:v>590</c:v>
                </c:pt>
                <c:pt idx="119" formatCode="General">
                  <c:v>595</c:v>
                </c:pt>
                <c:pt idx="120" formatCode="General">
                  <c:v>600</c:v>
                </c:pt>
                <c:pt idx="121" formatCode="General">
                  <c:v>605</c:v>
                </c:pt>
                <c:pt idx="122" formatCode="General">
                  <c:v>610</c:v>
                </c:pt>
                <c:pt idx="123" formatCode="General">
                  <c:v>615</c:v>
                </c:pt>
                <c:pt idx="124" formatCode="General">
                  <c:v>620</c:v>
                </c:pt>
                <c:pt idx="125" formatCode="General">
                  <c:v>625</c:v>
                </c:pt>
                <c:pt idx="126" formatCode="General">
                  <c:v>630</c:v>
                </c:pt>
                <c:pt idx="127" formatCode="General">
                  <c:v>635</c:v>
                </c:pt>
                <c:pt idx="128" formatCode="General">
                  <c:v>640</c:v>
                </c:pt>
                <c:pt idx="129" formatCode="General">
                  <c:v>645</c:v>
                </c:pt>
                <c:pt idx="130" formatCode="General">
                  <c:v>650</c:v>
                </c:pt>
                <c:pt idx="131" formatCode="General">
                  <c:v>655</c:v>
                </c:pt>
                <c:pt idx="132" formatCode="General">
                  <c:v>660</c:v>
                </c:pt>
                <c:pt idx="133" formatCode="General">
                  <c:v>665</c:v>
                </c:pt>
                <c:pt idx="134" formatCode="General">
                  <c:v>670</c:v>
                </c:pt>
                <c:pt idx="135" formatCode="General">
                  <c:v>675</c:v>
                </c:pt>
                <c:pt idx="136" formatCode="General">
                  <c:v>680</c:v>
                </c:pt>
                <c:pt idx="137" formatCode="General">
                  <c:v>685</c:v>
                </c:pt>
                <c:pt idx="138" formatCode="General">
                  <c:v>690</c:v>
                </c:pt>
                <c:pt idx="139" formatCode="General">
                  <c:v>695</c:v>
                </c:pt>
                <c:pt idx="140" formatCode="General">
                  <c:v>700</c:v>
                </c:pt>
                <c:pt idx="141" formatCode="General">
                  <c:v>705</c:v>
                </c:pt>
                <c:pt idx="142" formatCode="General">
                  <c:v>710</c:v>
                </c:pt>
                <c:pt idx="143" formatCode="General">
                  <c:v>715</c:v>
                </c:pt>
                <c:pt idx="144" formatCode="General">
                  <c:v>720</c:v>
                </c:pt>
                <c:pt idx="145" formatCode="General">
                  <c:v>725</c:v>
                </c:pt>
                <c:pt idx="146" formatCode="General">
                  <c:v>730</c:v>
                </c:pt>
                <c:pt idx="147" formatCode="General">
                  <c:v>735</c:v>
                </c:pt>
                <c:pt idx="148" formatCode="General">
                  <c:v>740</c:v>
                </c:pt>
                <c:pt idx="149" formatCode="General">
                  <c:v>745</c:v>
                </c:pt>
                <c:pt idx="150" formatCode="General">
                  <c:v>750</c:v>
                </c:pt>
                <c:pt idx="151" formatCode="General">
                  <c:v>755</c:v>
                </c:pt>
                <c:pt idx="152" formatCode="General">
                  <c:v>760</c:v>
                </c:pt>
                <c:pt idx="153" formatCode="General">
                  <c:v>765</c:v>
                </c:pt>
                <c:pt idx="154" formatCode="General">
                  <c:v>770</c:v>
                </c:pt>
                <c:pt idx="155" formatCode="General">
                  <c:v>775</c:v>
                </c:pt>
                <c:pt idx="156" formatCode="General">
                  <c:v>780</c:v>
                </c:pt>
                <c:pt idx="157" formatCode="General">
                  <c:v>785</c:v>
                </c:pt>
                <c:pt idx="158" formatCode="General">
                  <c:v>790</c:v>
                </c:pt>
                <c:pt idx="159" formatCode="General">
                  <c:v>795</c:v>
                </c:pt>
                <c:pt idx="160" formatCode="General">
                  <c:v>800</c:v>
                </c:pt>
                <c:pt idx="161" formatCode="General">
                  <c:v>805</c:v>
                </c:pt>
                <c:pt idx="162" formatCode="General">
                  <c:v>810</c:v>
                </c:pt>
                <c:pt idx="163" formatCode="General">
                  <c:v>815</c:v>
                </c:pt>
                <c:pt idx="164" formatCode="General">
                  <c:v>820</c:v>
                </c:pt>
                <c:pt idx="165" formatCode="General">
                  <c:v>825</c:v>
                </c:pt>
                <c:pt idx="166" formatCode="General">
                  <c:v>830</c:v>
                </c:pt>
                <c:pt idx="167" formatCode="General">
                  <c:v>835</c:v>
                </c:pt>
                <c:pt idx="168" formatCode="General">
                  <c:v>840</c:v>
                </c:pt>
                <c:pt idx="169" formatCode="General">
                  <c:v>845</c:v>
                </c:pt>
                <c:pt idx="170" formatCode="General">
                  <c:v>850</c:v>
                </c:pt>
                <c:pt idx="171" formatCode="General">
                  <c:v>855</c:v>
                </c:pt>
                <c:pt idx="172" formatCode="General">
                  <c:v>860</c:v>
                </c:pt>
                <c:pt idx="173" formatCode="General">
                  <c:v>865</c:v>
                </c:pt>
                <c:pt idx="174" formatCode="General">
                  <c:v>870</c:v>
                </c:pt>
                <c:pt idx="175" formatCode="General">
                  <c:v>875</c:v>
                </c:pt>
                <c:pt idx="176" formatCode="General">
                  <c:v>880</c:v>
                </c:pt>
                <c:pt idx="177" formatCode="General">
                  <c:v>885</c:v>
                </c:pt>
                <c:pt idx="178" formatCode="General">
                  <c:v>890</c:v>
                </c:pt>
                <c:pt idx="179" formatCode="General">
                  <c:v>895</c:v>
                </c:pt>
                <c:pt idx="180" formatCode="General">
                  <c:v>900</c:v>
                </c:pt>
                <c:pt idx="181" formatCode="General">
                  <c:v>905</c:v>
                </c:pt>
                <c:pt idx="182" formatCode="General">
                  <c:v>910</c:v>
                </c:pt>
                <c:pt idx="183" formatCode="General">
                  <c:v>915</c:v>
                </c:pt>
                <c:pt idx="184" formatCode="General">
                  <c:v>920</c:v>
                </c:pt>
                <c:pt idx="185" formatCode="General">
                  <c:v>925</c:v>
                </c:pt>
                <c:pt idx="186" formatCode="General">
                  <c:v>930</c:v>
                </c:pt>
                <c:pt idx="187" formatCode="General">
                  <c:v>935</c:v>
                </c:pt>
                <c:pt idx="188" formatCode="General">
                  <c:v>940</c:v>
                </c:pt>
                <c:pt idx="189" formatCode="General">
                  <c:v>945</c:v>
                </c:pt>
                <c:pt idx="190" formatCode="General">
                  <c:v>950</c:v>
                </c:pt>
                <c:pt idx="191" formatCode="General">
                  <c:v>955</c:v>
                </c:pt>
                <c:pt idx="192" formatCode="General">
                  <c:v>960</c:v>
                </c:pt>
                <c:pt idx="193" formatCode="General">
                  <c:v>965</c:v>
                </c:pt>
                <c:pt idx="194" formatCode="General">
                  <c:v>970</c:v>
                </c:pt>
                <c:pt idx="195" formatCode="General">
                  <c:v>975</c:v>
                </c:pt>
                <c:pt idx="196" formatCode="General">
                  <c:v>980</c:v>
                </c:pt>
                <c:pt idx="197" formatCode="General">
                  <c:v>985</c:v>
                </c:pt>
                <c:pt idx="198" formatCode="General">
                  <c:v>990</c:v>
                </c:pt>
                <c:pt idx="199" formatCode="General">
                  <c:v>995</c:v>
                </c:pt>
              </c:numCache>
            </c:numRef>
          </c:xVal>
          <c:yVal>
            <c:numRef>
              <c:f>Feuil1!$C$3:$C$202</c:f>
              <c:numCache>
                <c:formatCode>0.00</c:formatCode>
                <c:ptCount val="200"/>
                <c:pt idx="0">
                  <c:v>3.621</c:v>
                </c:pt>
                <c:pt idx="1">
                  <c:v>3.5430000000000001</c:v>
                </c:pt>
                <c:pt idx="2">
                  <c:v>3.5030000000000001</c:v>
                </c:pt>
                <c:pt idx="3">
                  <c:v>3.4630000000000001</c:v>
                </c:pt>
                <c:pt idx="4">
                  <c:v>3.4420000000000002</c:v>
                </c:pt>
                <c:pt idx="5">
                  <c:v>3.4249999999999998</c:v>
                </c:pt>
                <c:pt idx="6">
                  <c:v>3.4079999999999999</c:v>
                </c:pt>
                <c:pt idx="7">
                  <c:v>3.39</c:v>
                </c:pt>
                <c:pt idx="8">
                  <c:v>3.379</c:v>
                </c:pt>
                <c:pt idx="9">
                  <c:v>3.3549999999999991</c:v>
                </c:pt>
                <c:pt idx="10">
                  <c:v>3.343</c:v>
                </c:pt>
                <c:pt idx="11">
                  <c:v>3.3359999999999981</c:v>
                </c:pt>
                <c:pt idx="12">
                  <c:v>3.327</c:v>
                </c:pt>
                <c:pt idx="13">
                  <c:v>3.3159999999999981</c:v>
                </c:pt>
                <c:pt idx="14">
                  <c:v>3.3250000000000002</c:v>
                </c:pt>
                <c:pt idx="15">
                  <c:v>3.3069999999999999</c:v>
                </c:pt>
                <c:pt idx="16">
                  <c:v>3.3260000000000001</c:v>
                </c:pt>
                <c:pt idx="17">
                  <c:v>3.3090000000000002</c:v>
                </c:pt>
                <c:pt idx="18">
                  <c:v>3.294</c:v>
                </c:pt>
                <c:pt idx="19">
                  <c:v>3.28</c:v>
                </c:pt>
                <c:pt idx="20">
                  <c:v>3.274</c:v>
                </c:pt>
                <c:pt idx="21">
                  <c:v>3.2589999999999999</c:v>
                </c:pt>
                <c:pt idx="22">
                  <c:v>3.2669999999999999</c:v>
                </c:pt>
                <c:pt idx="23">
                  <c:v>3.2690000000000001</c:v>
                </c:pt>
                <c:pt idx="24">
                  <c:v>4.7380000000000004</c:v>
                </c:pt>
                <c:pt idx="25">
                  <c:v>7.4749999999999996</c:v>
                </c:pt>
                <c:pt idx="26">
                  <c:v>7.4009999999999998</c:v>
                </c:pt>
                <c:pt idx="27">
                  <c:v>7.3039999999999976</c:v>
                </c:pt>
                <c:pt idx="28">
                  <c:v>7.2160000000000002</c:v>
                </c:pt>
                <c:pt idx="29">
                  <c:v>7.1439999999999984</c:v>
                </c:pt>
                <c:pt idx="30">
                  <c:v>7.0810000000000004</c:v>
                </c:pt>
                <c:pt idx="31">
                  <c:v>7.0010000000000003</c:v>
                </c:pt>
                <c:pt idx="32" formatCode="General">
                  <c:v>6.96</c:v>
                </c:pt>
                <c:pt idx="33" formatCode="General">
                  <c:v>6.9020000000000001</c:v>
                </c:pt>
                <c:pt idx="34" formatCode="General">
                  <c:v>6.8460000000000001</c:v>
                </c:pt>
                <c:pt idx="35" formatCode="General">
                  <c:v>6.7880000000000003</c:v>
                </c:pt>
                <c:pt idx="36" formatCode="General">
                  <c:v>6.7290000000000001</c:v>
                </c:pt>
                <c:pt idx="37" formatCode="General">
                  <c:v>6.6649999999999974</c:v>
                </c:pt>
                <c:pt idx="38" formatCode="General">
                  <c:v>6.6249999999999973</c:v>
                </c:pt>
                <c:pt idx="39" formatCode="General">
                  <c:v>6.5780000000000003</c:v>
                </c:pt>
                <c:pt idx="40" formatCode="General">
                  <c:v>6.5369999999999999</c:v>
                </c:pt>
                <c:pt idx="41" formatCode="General">
                  <c:v>6.4820000000000002</c:v>
                </c:pt>
                <c:pt idx="42" formatCode="General">
                  <c:v>6.444</c:v>
                </c:pt>
                <c:pt idx="43" formatCode="General">
                  <c:v>6.3860000000000001</c:v>
                </c:pt>
                <c:pt idx="44" formatCode="General">
                  <c:v>8.2970000000000006</c:v>
                </c:pt>
                <c:pt idx="45" formatCode="General">
                  <c:v>9.6319999999999997</c:v>
                </c:pt>
                <c:pt idx="46" formatCode="General">
                  <c:v>9.5449999999999999</c:v>
                </c:pt>
                <c:pt idx="47" formatCode="General">
                  <c:v>9.4459999999999997</c:v>
                </c:pt>
                <c:pt idx="48" formatCode="General">
                  <c:v>9.3510000000000009</c:v>
                </c:pt>
                <c:pt idx="49" formatCode="General">
                  <c:v>9.2530000000000001</c:v>
                </c:pt>
                <c:pt idx="50" formatCode="General">
                  <c:v>9.1530000000000005</c:v>
                </c:pt>
                <c:pt idx="51" formatCode="General">
                  <c:v>9.0449999999999999</c:v>
                </c:pt>
                <c:pt idx="52" formatCode="General">
                  <c:v>8.9659999999999993</c:v>
                </c:pt>
                <c:pt idx="53" formatCode="General">
                  <c:v>8.8759999999999994</c:v>
                </c:pt>
                <c:pt idx="54" formatCode="General">
                  <c:v>8.8249999999999993</c:v>
                </c:pt>
                <c:pt idx="55" formatCode="General">
                  <c:v>8.7479999999999976</c:v>
                </c:pt>
                <c:pt idx="56" formatCode="General">
                  <c:v>8.6669999999999998</c:v>
                </c:pt>
                <c:pt idx="57" formatCode="General">
                  <c:v>8.57</c:v>
                </c:pt>
                <c:pt idx="58" formatCode="General">
                  <c:v>8.5470000000000006</c:v>
                </c:pt>
                <c:pt idx="59" formatCode="General">
                  <c:v>8.4600000000000009</c:v>
                </c:pt>
                <c:pt idx="60" formatCode="General">
                  <c:v>8.3930000000000007</c:v>
                </c:pt>
                <c:pt idx="61" formatCode="General">
                  <c:v>8.3520000000000003</c:v>
                </c:pt>
                <c:pt idx="62" formatCode="General">
                  <c:v>8.7739999999999991</c:v>
                </c:pt>
                <c:pt idx="63" formatCode="General">
                  <c:v>11.29</c:v>
                </c:pt>
                <c:pt idx="64" formatCode="General">
                  <c:v>11.18</c:v>
                </c:pt>
                <c:pt idx="65" formatCode="General">
                  <c:v>11.06</c:v>
                </c:pt>
                <c:pt idx="66" formatCode="General">
                  <c:v>10.96</c:v>
                </c:pt>
                <c:pt idx="67" formatCode="General">
                  <c:v>10.82</c:v>
                </c:pt>
                <c:pt idx="68" formatCode="General">
                  <c:v>10.72</c:v>
                </c:pt>
                <c:pt idx="69" formatCode="General">
                  <c:v>10.64</c:v>
                </c:pt>
                <c:pt idx="70" formatCode="General">
                  <c:v>10.54</c:v>
                </c:pt>
                <c:pt idx="71" formatCode="General">
                  <c:v>10.45</c:v>
                </c:pt>
                <c:pt idx="72" formatCode="General">
                  <c:v>10.39</c:v>
                </c:pt>
                <c:pt idx="73" formatCode="General">
                  <c:v>10.29</c:v>
                </c:pt>
                <c:pt idx="74" formatCode="General">
                  <c:v>10.24</c:v>
                </c:pt>
                <c:pt idx="75" formatCode="General">
                  <c:v>10.16</c:v>
                </c:pt>
                <c:pt idx="76" formatCode="General">
                  <c:v>10.050000000000001</c:v>
                </c:pt>
                <c:pt idx="77" formatCode="General">
                  <c:v>10.02</c:v>
                </c:pt>
                <c:pt idx="78" formatCode="General">
                  <c:v>9.9359999999999999</c:v>
                </c:pt>
                <c:pt idx="79" formatCode="General">
                  <c:v>9.8469999999999995</c:v>
                </c:pt>
                <c:pt idx="80" formatCode="General">
                  <c:v>9.7810000000000006</c:v>
                </c:pt>
                <c:pt idx="81" formatCode="General">
                  <c:v>10.85</c:v>
                </c:pt>
                <c:pt idx="82" formatCode="General">
                  <c:v>12.34</c:v>
                </c:pt>
                <c:pt idx="83" formatCode="General">
                  <c:v>12.25</c:v>
                </c:pt>
                <c:pt idx="84" formatCode="General">
                  <c:v>12.14</c:v>
                </c:pt>
                <c:pt idx="85" formatCode="General">
                  <c:v>12.05</c:v>
                </c:pt>
                <c:pt idx="86" formatCode="General">
                  <c:v>11.95</c:v>
                </c:pt>
                <c:pt idx="87" formatCode="General">
                  <c:v>11.86</c:v>
                </c:pt>
                <c:pt idx="88" formatCode="General">
                  <c:v>11.78</c:v>
                </c:pt>
                <c:pt idx="89" formatCode="General">
                  <c:v>11.72</c:v>
                </c:pt>
                <c:pt idx="90" formatCode="General">
                  <c:v>11.64</c:v>
                </c:pt>
                <c:pt idx="91" formatCode="General">
                  <c:v>11.55</c:v>
                </c:pt>
                <c:pt idx="92" formatCode="General">
                  <c:v>11.46</c:v>
                </c:pt>
                <c:pt idx="93" formatCode="General">
                  <c:v>11.38</c:v>
                </c:pt>
                <c:pt idx="94" formatCode="General">
                  <c:v>11.3</c:v>
                </c:pt>
                <c:pt idx="95" formatCode="General">
                  <c:v>11.26</c:v>
                </c:pt>
                <c:pt idx="96" formatCode="General">
                  <c:v>11.19</c:v>
                </c:pt>
                <c:pt idx="97" formatCode="General">
                  <c:v>11.09</c:v>
                </c:pt>
                <c:pt idx="98" formatCode="General">
                  <c:v>11.02</c:v>
                </c:pt>
                <c:pt idx="99" formatCode="General">
                  <c:v>11.43</c:v>
                </c:pt>
                <c:pt idx="100" formatCode="General">
                  <c:v>13.33</c:v>
                </c:pt>
                <c:pt idx="101" formatCode="General">
                  <c:v>13.24</c:v>
                </c:pt>
                <c:pt idx="102" formatCode="General">
                  <c:v>13.16</c:v>
                </c:pt>
                <c:pt idx="103" formatCode="General">
                  <c:v>13.1</c:v>
                </c:pt>
                <c:pt idx="104" formatCode="General">
                  <c:v>13</c:v>
                </c:pt>
                <c:pt idx="105" formatCode="General">
                  <c:v>12.92</c:v>
                </c:pt>
                <c:pt idx="106" formatCode="General">
                  <c:v>12.88</c:v>
                </c:pt>
                <c:pt idx="107" formatCode="General">
                  <c:v>12.81</c:v>
                </c:pt>
                <c:pt idx="108" formatCode="General">
                  <c:v>12.75</c:v>
                </c:pt>
                <c:pt idx="109" formatCode="General">
                  <c:v>12.67</c:v>
                </c:pt>
                <c:pt idx="110" formatCode="General">
                  <c:v>12.64</c:v>
                </c:pt>
                <c:pt idx="111" formatCode="General">
                  <c:v>12.56</c:v>
                </c:pt>
                <c:pt idx="112" formatCode="General">
                  <c:v>12.49</c:v>
                </c:pt>
                <c:pt idx="113" formatCode="General">
                  <c:v>12.45</c:v>
                </c:pt>
                <c:pt idx="114" formatCode="General">
                  <c:v>12.4</c:v>
                </c:pt>
                <c:pt idx="115" formatCode="General">
                  <c:v>12.36</c:v>
                </c:pt>
                <c:pt idx="116" formatCode="General">
                  <c:v>12.3</c:v>
                </c:pt>
                <c:pt idx="117" formatCode="General">
                  <c:v>12.24</c:v>
                </c:pt>
                <c:pt idx="118" formatCode="General">
                  <c:v>12.8</c:v>
                </c:pt>
                <c:pt idx="119" formatCode="General">
                  <c:v>14.24</c:v>
                </c:pt>
                <c:pt idx="120" formatCode="General">
                  <c:v>14.21</c:v>
                </c:pt>
                <c:pt idx="121" formatCode="General">
                  <c:v>14.16</c:v>
                </c:pt>
                <c:pt idx="122" formatCode="General">
                  <c:v>14.15</c:v>
                </c:pt>
                <c:pt idx="123" formatCode="General">
                  <c:v>14.1</c:v>
                </c:pt>
                <c:pt idx="124" formatCode="General">
                  <c:v>14.04</c:v>
                </c:pt>
                <c:pt idx="125" formatCode="General">
                  <c:v>13.97</c:v>
                </c:pt>
                <c:pt idx="126" formatCode="General">
                  <c:v>13.95</c:v>
                </c:pt>
                <c:pt idx="127" formatCode="General">
                  <c:v>13.93</c:v>
                </c:pt>
                <c:pt idx="128" formatCode="General">
                  <c:v>13.91</c:v>
                </c:pt>
                <c:pt idx="129" formatCode="General">
                  <c:v>13.88</c:v>
                </c:pt>
                <c:pt idx="130" formatCode="General">
                  <c:v>13.86</c:v>
                </c:pt>
                <c:pt idx="131" formatCode="General">
                  <c:v>13.84</c:v>
                </c:pt>
                <c:pt idx="132" formatCode="General">
                  <c:v>13.81</c:v>
                </c:pt>
                <c:pt idx="133" formatCode="General">
                  <c:v>13.79</c:v>
                </c:pt>
                <c:pt idx="134" formatCode="General">
                  <c:v>13.8</c:v>
                </c:pt>
                <c:pt idx="135" formatCode="General">
                  <c:v>13.77</c:v>
                </c:pt>
                <c:pt idx="136" formatCode="General">
                  <c:v>13.76</c:v>
                </c:pt>
                <c:pt idx="137" formatCode="General">
                  <c:v>13.75</c:v>
                </c:pt>
                <c:pt idx="138" formatCode="General">
                  <c:v>13.97</c:v>
                </c:pt>
                <c:pt idx="139" formatCode="General">
                  <c:v>15.5</c:v>
                </c:pt>
                <c:pt idx="140" formatCode="General">
                  <c:v>15.49</c:v>
                </c:pt>
                <c:pt idx="141" formatCode="General">
                  <c:v>15.48</c:v>
                </c:pt>
                <c:pt idx="142" formatCode="General">
                  <c:v>15.49</c:v>
                </c:pt>
                <c:pt idx="143" formatCode="General">
                  <c:v>15.49</c:v>
                </c:pt>
                <c:pt idx="144" formatCode="General">
                  <c:v>15.48</c:v>
                </c:pt>
                <c:pt idx="145" formatCode="General">
                  <c:v>15.48</c:v>
                </c:pt>
                <c:pt idx="146" formatCode="General">
                  <c:v>15.47</c:v>
                </c:pt>
                <c:pt idx="147" formatCode="General">
                  <c:v>15.49</c:v>
                </c:pt>
                <c:pt idx="148" formatCode="General">
                  <c:v>15.49</c:v>
                </c:pt>
                <c:pt idx="149" formatCode="General">
                  <c:v>15.5</c:v>
                </c:pt>
                <c:pt idx="150" formatCode="General">
                  <c:v>15.52</c:v>
                </c:pt>
                <c:pt idx="151" formatCode="General">
                  <c:v>15.5</c:v>
                </c:pt>
                <c:pt idx="152" formatCode="General">
                  <c:v>15.52</c:v>
                </c:pt>
                <c:pt idx="153" formatCode="General">
                  <c:v>15.55</c:v>
                </c:pt>
                <c:pt idx="154" formatCode="General">
                  <c:v>15.56</c:v>
                </c:pt>
                <c:pt idx="155" formatCode="General">
                  <c:v>15.56</c:v>
                </c:pt>
                <c:pt idx="156" formatCode="General">
                  <c:v>15.57</c:v>
                </c:pt>
                <c:pt idx="157" formatCode="General">
                  <c:v>15.6</c:v>
                </c:pt>
                <c:pt idx="158" formatCode="General">
                  <c:v>15.59</c:v>
                </c:pt>
                <c:pt idx="159" formatCode="General">
                  <c:v>15.61</c:v>
                </c:pt>
                <c:pt idx="160" formatCode="General">
                  <c:v>15.66</c:v>
                </c:pt>
                <c:pt idx="161" formatCode="General">
                  <c:v>15.66</c:v>
                </c:pt>
                <c:pt idx="162" formatCode="General">
                  <c:v>15.7</c:v>
                </c:pt>
                <c:pt idx="163" formatCode="General">
                  <c:v>15.72</c:v>
                </c:pt>
                <c:pt idx="164" formatCode="General">
                  <c:v>15.73</c:v>
                </c:pt>
                <c:pt idx="165" formatCode="General">
                  <c:v>15.78</c:v>
                </c:pt>
                <c:pt idx="166" formatCode="General">
                  <c:v>15.83</c:v>
                </c:pt>
                <c:pt idx="167" formatCode="General">
                  <c:v>15.85</c:v>
                </c:pt>
                <c:pt idx="168" formatCode="General">
                  <c:v>15.88</c:v>
                </c:pt>
                <c:pt idx="169" formatCode="General">
                  <c:v>15.92</c:v>
                </c:pt>
                <c:pt idx="170" formatCode="General">
                  <c:v>15.96</c:v>
                </c:pt>
                <c:pt idx="171" formatCode="General">
                  <c:v>16.02</c:v>
                </c:pt>
                <c:pt idx="172" formatCode="General">
                  <c:v>16.04</c:v>
                </c:pt>
                <c:pt idx="173" formatCode="General">
                  <c:v>16.07</c:v>
                </c:pt>
                <c:pt idx="174" formatCode="General">
                  <c:v>16.079999999999998</c:v>
                </c:pt>
                <c:pt idx="175" formatCode="General">
                  <c:v>16.12</c:v>
                </c:pt>
                <c:pt idx="176" formatCode="General">
                  <c:v>16.170000000000002</c:v>
                </c:pt>
                <c:pt idx="177" formatCode="General">
                  <c:v>16.190000000000001</c:v>
                </c:pt>
                <c:pt idx="178" formatCode="General">
                  <c:v>16.23</c:v>
                </c:pt>
                <c:pt idx="179" formatCode="General">
                  <c:v>16.28</c:v>
                </c:pt>
                <c:pt idx="180" formatCode="General">
                  <c:v>16.32</c:v>
                </c:pt>
                <c:pt idx="181" formatCode="General">
                  <c:v>16.350000000000001</c:v>
                </c:pt>
                <c:pt idx="182" formatCode="General">
                  <c:v>16.399999999999999</c:v>
                </c:pt>
                <c:pt idx="183" formatCode="General">
                  <c:v>16.440000000000001</c:v>
                </c:pt>
                <c:pt idx="184" formatCode="General">
                  <c:v>16.489999999999998</c:v>
                </c:pt>
                <c:pt idx="185" formatCode="General">
                  <c:v>16.52</c:v>
                </c:pt>
                <c:pt idx="186" formatCode="General">
                  <c:v>16.559999999999999</c:v>
                </c:pt>
                <c:pt idx="187" formatCode="General">
                  <c:v>16.579999999999998</c:v>
                </c:pt>
                <c:pt idx="188" formatCode="General">
                  <c:v>16.64</c:v>
                </c:pt>
                <c:pt idx="189" formatCode="General">
                  <c:v>16.670000000000002</c:v>
                </c:pt>
                <c:pt idx="190" formatCode="General">
                  <c:v>16.72</c:v>
                </c:pt>
                <c:pt idx="191" formatCode="General">
                  <c:v>16.77</c:v>
                </c:pt>
                <c:pt idx="192" formatCode="General">
                  <c:v>16.809999999999999</c:v>
                </c:pt>
                <c:pt idx="193" formatCode="General">
                  <c:v>16.88</c:v>
                </c:pt>
                <c:pt idx="194" formatCode="General">
                  <c:v>16.940000000000001</c:v>
                </c:pt>
                <c:pt idx="195" formatCode="General">
                  <c:v>16.96</c:v>
                </c:pt>
                <c:pt idx="196" formatCode="General">
                  <c:v>17.010000000000002</c:v>
                </c:pt>
                <c:pt idx="197" formatCode="General">
                  <c:v>17.05</c:v>
                </c:pt>
                <c:pt idx="198" formatCode="General">
                  <c:v>17.11</c:v>
                </c:pt>
                <c:pt idx="199" formatCode="General">
                  <c:v>17.14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51C-FD48-BF37-2CF52A18E8C3}"/>
            </c:ext>
          </c:extLst>
        </c:ser>
        <c:ser>
          <c:idx val="2"/>
          <c:order val="2"/>
          <c:tx>
            <c:strRef>
              <c:f>Feuil1!$D$2</c:f>
              <c:strCache>
                <c:ptCount val="1"/>
              </c:strCache>
            </c:strRef>
          </c:tx>
          <c:spPr>
            <a:ln w="28575" cap="rnd" cmpd="sng">
              <a:solidFill>
                <a:srgbClr val="0000FF"/>
              </a:solidFill>
              <a:round/>
            </a:ln>
            <a:effectLst/>
          </c:spPr>
          <c:marker>
            <c:symbol val="none"/>
          </c:marker>
          <c:xVal>
            <c:numRef>
              <c:f>Feuil1!$A$3:$A$202</c:f>
              <c:numCache>
                <c:formatCode>0.00</c:formatCode>
                <c:ptCount val="200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  <c:pt idx="25">
                  <c:v>125</c:v>
                </c:pt>
                <c:pt idx="26">
                  <c:v>130</c:v>
                </c:pt>
                <c:pt idx="27">
                  <c:v>135</c:v>
                </c:pt>
                <c:pt idx="28">
                  <c:v>140</c:v>
                </c:pt>
                <c:pt idx="29">
                  <c:v>145</c:v>
                </c:pt>
                <c:pt idx="30">
                  <c:v>150</c:v>
                </c:pt>
                <c:pt idx="31">
                  <c:v>155</c:v>
                </c:pt>
                <c:pt idx="32" formatCode="General">
                  <c:v>160</c:v>
                </c:pt>
                <c:pt idx="33" formatCode="General">
                  <c:v>165</c:v>
                </c:pt>
                <c:pt idx="34" formatCode="General">
                  <c:v>170</c:v>
                </c:pt>
                <c:pt idx="35" formatCode="General">
                  <c:v>175</c:v>
                </c:pt>
                <c:pt idx="36" formatCode="General">
                  <c:v>180</c:v>
                </c:pt>
                <c:pt idx="37" formatCode="General">
                  <c:v>185</c:v>
                </c:pt>
                <c:pt idx="38" formatCode="General">
                  <c:v>190</c:v>
                </c:pt>
                <c:pt idx="39" formatCode="General">
                  <c:v>195</c:v>
                </c:pt>
                <c:pt idx="40" formatCode="General">
                  <c:v>200</c:v>
                </c:pt>
                <c:pt idx="41" formatCode="General">
                  <c:v>205</c:v>
                </c:pt>
                <c:pt idx="42" formatCode="General">
                  <c:v>210</c:v>
                </c:pt>
                <c:pt idx="43" formatCode="General">
                  <c:v>215</c:v>
                </c:pt>
                <c:pt idx="44" formatCode="General">
                  <c:v>220</c:v>
                </c:pt>
                <c:pt idx="45" formatCode="General">
                  <c:v>225</c:v>
                </c:pt>
                <c:pt idx="46" formatCode="General">
                  <c:v>230</c:v>
                </c:pt>
                <c:pt idx="47" formatCode="General">
                  <c:v>235</c:v>
                </c:pt>
                <c:pt idx="48" formatCode="General">
                  <c:v>240</c:v>
                </c:pt>
                <c:pt idx="49" formatCode="General">
                  <c:v>245</c:v>
                </c:pt>
                <c:pt idx="50" formatCode="General">
                  <c:v>250</c:v>
                </c:pt>
                <c:pt idx="51" formatCode="General">
                  <c:v>255</c:v>
                </c:pt>
                <c:pt idx="52" formatCode="General">
                  <c:v>260</c:v>
                </c:pt>
                <c:pt idx="53" formatCode="General">
                  <c:v>265</c:v>
                </c:pt>
                <c:pt idx="54" formatCode="General">
                  <c:v>270</c:v>
                </c:pt>
                <c:pt idx="55" formatCode="General">
                  <c:v>275</c:v>
                </c:pt>
                <c:pt idx="56" formatCode="General">
                  <c:v>280</c:v>
                </c:pt>
                <c:pt idx="57" formatCode="General">
                  <c:v>285</c:v>
                </c:pt>
                <c:pt idx="58" formatCode="General">
                  <c:v>290</c:v>
                </c:pt>
                <c:pt idx="59" formatCode="General">
                  <c:v>295</c:v>
                </c:pt>
                <c:pt idx="60" formatCode="General">
                  <c:v>300</c:v>
                </c:pt>
                <c:pt idx="61" formatCode="General">
                  <c:v>305</c:v>
                </c:pt>
                <c:pt idx="62" formatCode="General">
                  <c:v>310</c:v>
                </c:pt>
                <c:pt idx="63" formatCode="General">
                  <c:v>315</c:v>
                </c:pt>
                <c:pt idx="64" formatCode="General">
                  <c:v>320</c:v>
                </c:pt>
                <c:pt idx="65" formatCode="General">
                  <c:v>325</c:v>
                </c:pt>
                <c:pt idx="66" formatCode="General">
                  <c:v>330</c:v>
                </c:pt>
                <c:pt idx="67" formatCode="General">
                  <c:v>335</c:v>
                </c:pt>
                <c:pt idx="68" formatCode="General">
                  <c:v>340</c:v>
                </c:pt>
                <c:pt idx="69" formatCode="General">
                  <c:v>345</c:v>
                </c:pt>
                <c:pt idx="70" formatCode="General">
                  <c:v>350</c:v>
                </c:pt>
                <c:pt idx="71" formatCode="General">
                  <c:v>355</c:v>
                </c:pt>
                <c:pt idx="72" formatCode="General">
                  <c:v>360</c:v>
                </c:pt>
                <c:pt idx="73" formatCode="General">
                  <c:v>365</c:v>
                </c:pt>
                <c:pt idx="74" formatCode="General">
                  <c:v>370</c:v>
                </c:pt>
                <c:pt idx="75" formatCode="General">
                  <c:v>375</c:v>
                </c:pt>
                <c:pt idx="76" formatCode="General">
                  <c:v>380</c:v>
                </c:pt>
                <c:pt idx="77" formatCode="General">
                  <c:v>385</c:v>
                </c:pt>
                <c:pt idx="78" formatCode="General">
                  <c:v>390</c:v>
                </c:pt>
                <c:pt idx="79" formatCode="General">
                  <c:v>395</c:v>
                </c:pt>
                <c:pt idx="80" formatCode="General">
                  <c:v>400</c:v>
                </c:pt>
                <c:pt idx="81" formatCode="General">
                  <c:v>405</c:v>
                </c:pt>
                <c:pt idx="82" formatCode="General">
                  <c:v>410</c:v>
                </c:pt>
                <c:pt idx="83" formatCode="General">
                  <c:v>415</c:v>
                </c:pt>
                <c:pt idx="84" formatCode="General">
                  <c:v>420</c:v>
                </c:pt>
                <c:pt idx="85" formatCode="General">
                  <c:v>425</c:v>
                </c:pt>
                <c:pt idx="86" formatCode="General">
                  <c:v>430</c:v>
                </c:pt>
                <c:pt idx="87" formatCode="General">
                  <c:v>435</c:v>
                </c:pt>
                <c:pt idx="88" formatCode="General">
                  <c:v>440</c:v>
                </c:pt>
                <c:pt idx="89" formatCode="General">
                  <c:v>445</c:v>
                </c:pt>
                <c:pt idx="90" formatCode="General">
                  <c:v>450</c:v>
                </c:pt>
                <c:pt idx="91" formatCode="General">
                  <c:v>455</c:v>
                </c:pt>
                <c:pt idx="92" formatCode="General">
                  <c:v>460</c:v>
                </c:pt>
                <c:pt idx="93" formatCode="General">
                  <c:v>465</c:v>
                </c:pt>
                <c:pt idx="94" formatCode="General">
                  <c:v>470</c:v>
                </c:pt>
                <c:pt idx="95" formatCode="General">
                  <c:v>475</c:v>
                </c:pt>
                <c:pt idx="96" formatCode="General">
                  <c:v>480</c:v>
                </c:pt>
                <c:pt idx="97" formatCode="General">
                  <c:v>485</c:v>
                </c:pt>
                <c:pt idx="98" formatCode="General">
                  <c:v>490</c:v>
                </c:pt>
                <c:pt idx="99" formatCode="General">
                  <c:v>495</c:v>
                </c:pt>
                <c:pt idx="100" formatCode="General">
                  <c:v>500</c:v>
                </c:pt>
                <c:pt idx="101" formatCode="General">
                  <c:v>505</c:v>
                </c:pt>
                <c:pt idx="102" formatCode="General">
                  <c:v>510</c:v>
                </c:pt>
                <c:pt idx="103" formatCode="General">
                  <c:v>515</c:v>
                </c:pt>
                <c:pt idx="104" formatCode="General">
                  <c:v>520</c:v>
                </c:pt>
                <c:pt idx="105" formatCode="General">
                  <c:v>525</c:v>
                </c:pt>
                <c:pt idx="106" formatCode="General">
                  <c:v>530</c:v>
                </c:pt>
                <c:pt idx="107" formatCode="General">
                  <c:v>535</c:v>
                </c:pt>
                <c:pt idx="108" formatCode="General">
                  <c:v>540</c:v>
                </c:pt>
                <c:pt idx="109" formatCode="General">
                  <c:v>545</c:v>
                </c:pt>
                <c:pt idx="110" formatCode="General">
                  <c:v>550</c:v>
                </c:pt>
                <c:pt idx="111" formatCode="General">
                  <c:v>555</c:v>
                </c:pt>
                <c:pt idx="112" formatCode="General">
                  <c:v>560</c:v>
                </c:pt>
                <c:pt idx="113" formatCode="General">
                  <c:v>565</c:v>
                </c:pt>
                <c:pt idx="114" formatCode="General">
                  <c:v>570</c:v>
                </c:pt>
                <c:pt idx="115" formatCode="General">
                  <c:v>575</c:v>
                </c:pt>
                <c:pt idx="116" formatCode="General">
                  <c:v>580</c:v>
                </c:pt>
                <c:pt idx="117" formatCode="General">
                  <c:v>585</c:v>
                </c:pt>
                <c:pt idx="118" formatCode="General">
                  <c:v>590</c:v>
                </c:pt>
                <c:pt idx="119" formatCode="General">
                  <c:v>595</c:v>
                </c:pt>
                <c:pt idx="120" formatCode="General">
                  <c:v>600</c:v>
                </c:pt>
                <c:pt idx="121" formatCode="General">
                  <c:v>605</c:v>
                </c:pt>
                <c:pt idx="122" formatCode="General">
                  <c:v>610</c:v>
                </c:pt>
                <c:pt idx="123" formatCode="General">
                  <c:v>615</c:v>
                </c:pt>
                <c:pt idx="124" formatCode="General">
                  <c:v>620</c:v>
                </c:pt>
                <c:pt idx="125" formatCode="General">
                  <c:v>625</c:v>
                </c:pt>
                <c:pt idx="126" formatCode="General">
                  <c:v>630</c:v>
                </c:pt>
                <c:pt idx="127" formatCode="General">
                  <c:v>635</c:v>
                </c:pt>
                <c:pt idx="128" formatCode="General">
                  <c:v>640</c:v>
                </c:pt>
                <c:pt idx="129" formatCode="General">
                  <c:v>645</c:v>
                </c:pt>
                <c:pt idx="130" formatCode="General">
                  <c:v>650</c:v>
                </c:pt>
                <c:pt idx="131" formatCode="General">
                  <c:v>655</c:v>
                </c:pt>
                <c:pt idx="132" formatCode="General">
                  <c:v>660</c:v>
                </c:pt>
                <c:pt idx="133" formatCode="General">
                  <c:v>665</c:v>
                </c:pt>
                <c:pt idx="134" formatCode="General">
                  <c:v>670</c:v>
                </c:pt>
                <c:pt idx="135" formatCode="General">
                  <c:v>675</c:v>
                </c:pt>
                <c:pt idx="136" formatCode="General">
                  <c:v>680</c:v>
                </c:pt>
                <c:pt idx="137" formatCode="General">
                  <c:v>685</c:v>
                </c:pt>
                <c:pt idx="138" formatCode="General">
                  <c:v>690</c:v>
                </c:pt>
                <c:pt idx="139" formatCode="General">
                  <c:v>695</c:v>
                </c:pt>
                <c:pt idx="140" formatCode="General">
                  <c:v>700</c:v>
                </c:pt>
                <c:pt idx="141" formatCode="General">
                  <c:v>705</c:v>
                </c:pt>
                <c:pt idx="142" formatCode="General">
                  <c:v>710</c:v>
                </c:pt>
                <c:pt idx="143" formatCode="General">
                  <c:v>715</c:v>
                </c:pt>
                <c:pt idx="144" formatCode="General">
                  <c:v>720</c:v>
                </c:pt>
                <c:pt idx="145" formatCode="General">
                  <c:v>725</c:v>
                </c:pt>
                <c:pt idx="146" formatCode="General">
                  <c:v>730</c:v>
                </c:pt>
                <c:pt idx="147" formatCode="General">
                  <c:v>735</c:v>
                </c:pt>
                <c:pt idx="148" formatCode="General">
                  <c:v>740</c:v>
                </c:pt>
                <c:pt idx="149" formatCode="General">
                  <c:v>745</c:v>
                </c:pt>
                <c:pt idx="150" formatCode="General">
                  <c:v>750</c:v>
                </c:pt>
                <c:pt idx="151" formatCode="General">
                  <c:v>755</c:v>
                </c:pt>
                <c:pt idx="152" formatCode="General">
                  <c:v>760</c:v>
                </c:pt>
                <c:pt idx="153" formatCode="General">
                  <c:v>765</c:v>
                </c:pt>
                <c:pt idx="154" formatCode="General">
                  <c:v>770</c:v>
                </c:pt>
                <c:pt idx="155" formatCode="General">
                  <c:v>775</c:v>
                </c:pt>
                <c:pt idx="156" formatCode="General">
                  <c:v>780</c:v>
                </c:pt>
                <c:pt idx="157" formatCode="General">
                  <c:v>785</c:v>
                </c:pt>
                <c:pt idx="158" formatCode="General">
                  <c:v>790</c:v>
                </c:pt>
                <c:pt idx="159" formatCode="General">
                  <c:v>795</c:v>
                </c:pt>
                <c:pt idx="160" formatCode="General">
                  <c:v>800</c:v>
                </c:pt>
                <c:pt idx="161" formatCode="General">
                  <c:v>805</c:v>
                </c:pt>
                <c:pt idx="162" formatCode="General">
                  <c:v>810</c:v>
                </c:pt>
                <c:pt idx="163" formatCode="General">
                  <c:v>815</c:v>
                </c:pt>
                <c:pt idx="164" formatCode="General">
                  <c:v>820</c:v>
                </c:pt>
                <c:pt idx="165" formatCode="General">
                  <c:v>825</c:v>
                </c:pt>
                <c:pt idx="166" formatCode="General">
                  <c:v>830</c:v>
                </c:pt>
                <c:pt idx="167" formatCode="General">
                  <c:v>835</c:v>
                </c:pt>
                <c:pt idx="168" formatCode="General">
                  <c:v>840</c:v>
                </c:pt>
                <c:pt idx="169" formatCode="General">
                  <c:v>845</c:v>
                </c:pt>
                <c:pt idx="170" formatCode="General">
                  <c:v>850</c:v>
                </c:pt>
                <c:pt idx="171" formatCode="General">
                  <c:v>855</c:v>
                </c:pt>
                <c:pt idx="172" formatCode="General">
                  <c:v>860</c:v>
                </c:pt>
                <c:pt idx="173" formatCode="General">
                  <c:v>865</c:v>
                </c:pt>
                <c:pt idx="174" formatCode="General">
                  <c:v>870</c:v>
                </c:pt>
                <c:pt idx="175" formatCode="General">
                  <c:v>875</c:v>
                </c:pt>
                <c:pt idx="176" formatCode="General">
                  <c:v>880</c:v>
                </c:pt>
                <c:pt idx="177" formatCode="General">
                  <c:v>885</c:v>
                </c:pt>
                <c:pt idx="178" formatCode="General">
                  <c:v>890</c:v>
                </c:pt>
                <c:pt idx="179" formatCode="General">
                  <c:v>895</c:v>
                </c:pt>
                <c:pt idx="180" formatCode="General">
                  <c:v>900</c:v>
                </c:pt>
                <c:pt idx="181" formatCode="General">
                  <c:v>905</c:v>
                </c:pt>
                <c:pt idx="182" formatCode="General">
                  <c:v>910</c:v>
                </c:pt>
                <c:pt idx="183" formatCode="General">
                  <c:v>915</c:v>
                </c:pt>
                <c:pt idx="184" formatCode="General">
                  <c:v>920</c:v>
                </c:pt>
                <c:pt idx="185" formatCode="General">
                  <c:v>925</c:v>
                </c:pt>
                <c:pt idx="186" formatCode="General">
                  <c:v>930</c:v>
                </c:pt>
                <c:pt idx="187" formatCode="General">
                  <c:v>935</c:v>
                </c:pt>
                <c:pt idx="188" formatCode="General">
                  <c:v>940</c:v>
                </c:pt>
                <c:pt idx="189" formatCode="General">
                  <c:v>945</c:v>
                </c:pt>
                <c:pt idx="190" formatCode="General">
                  <c:v>950</c:v>
                </c:pt>
                <c:pt idx="191" formatCode="General">
                  <c:v>955</c:v>
                </c:pt>
                <c:pt idx="192" formatCode="General">
                  <c:v>960</c:v>
                </c:pt>
                <c:pt idx="193" formatCode="General">
                  <c:v>965</c:v>
                </c:pt>
                <c:pt idx="194" formatCode="General">
                  <c:v>970</c:v>
                </c:pt>
                <c:pt idx="195" formatCode="General">
                  <c:v>975</c:v>
                </c:pt>
                <c:pt idx="196" formatCode="General">
                  <c:v>980</c:v>
                </c:pt>
                <c:pt idx="197" formatCode="General">
                  <c:v>985</c:v>
                </c:pt>
                <c:pt idx="198" formatCode="General">
                  <c:v>990</c:v>
                </c:pt>
                <c:pt idx="199" formatCode="General">
                  <c:v>995</c:v>
                </c:pt>
              </c:numCache>
            </c:numRef>
          </c:xVal>
          <c:yVal>
            <c:numRef>
              <c:f>Feuil1!$D$3:$D$202</c:f>
              <c:numCache>
                <c:formatCode>0.00</c:formatCode>
                <c:ptCount val="200"/>
                <c:pt idx="0">
                  <c:v>3.52</c:v>
                </c:pt>
                <c:pt idx="1">
                  <c:v>3.5310000000000001</c:v>
                </c:pt>
                <c:pt idx="2">
                  <c:v>3.5369999999999999</c:v>
                </c:pt>
                <c:pt idx="3">
                  <c:v>3.5369999999999999</c:v>
                </c:pt>
                <c:pt idx="4">
                  <c:v>3.5459999999999998</c:v>
                </c:pt>
                <c:pt idx="5">
                  <c:v>3.5760000000000001</c:v>
                </c:pt>
                <c:pt idx="6">
                  <c:v>3.5630000000000002</c:v>
                </c:pt>
                <c:pt idx="7">
                  <c:v>3.5659999999999998</c:v>
                </c:pt>
                <c:pt idx="8">
                  <c:v>3.5569999999999999</c:v>
                </c:pt>
                <c:pt idx="9">
                  <c:v>3.56</c:v>
                </c:pt>
                <c:pt idx="10">
                  <c:v>3.528</c:v>
                </c:pt>
                <c:pt idx="11">
                  <c:v>3.512</c:v>
                </c:pt>
                <c:pt idx="12">
                  <c:v>3.516</c:v>
                </c:pt>
                <c:pt idx="13">
                  <c:v>3.51</c:v>
                </c:pt>
                <c:pt idx="14">
                  <c:v>3.5150000000000001</c:v>
                </c:pt>
                <c:pt idx="15">
                  <c:v>3.5110000000000001</c:v>
                </c:pt>
                <c:pt idx="16">
                  <c:v>3.4740000000000002</c:v>
                </c:pt>
                <c:pt idx="17">
                  <c:v>3.4540000000000002</c:v>
                </c:pt>
                <c:pt idx="18">
                  <c:v>3.4390000000000001</c:v>
                </c:pt>
                <c:pt idx="19">
                  <c:v>3.4380000000000002</c:v>
                </c:pt>
                <c:pt idx="20">
                  <c:v>3.4449999999999998</c:v>
                </c:pt>
                <c:pt idx="21">
                  <c:v>3.4089999999999998</c:v>
                </c:pt>
                <c:pt idx="22">
                  <c:v>3.38</c:v>
                </c:pt>
                <c:pt idx="23">
                  <c:v>3.3679999999999999</c:v>
                </c:pt>
                <c:pt idx="24">
                  <c:v>3.38</c:v>
                </c:pt>
                <c:pt idx="25">
                  <c:v>3.3929999999999998</c:v>
                </c:pt>
                <c:pt idx="26">
                  <c:v>3.38</c:v>
                </c:pt>
                <c:pt idx="27">
                  <c:v>5.1459999999999999</c:v>
                </c:pt>
                <c:pt idx="28">
                  <c:v>7.1059999999999999</c:v>
                </c:pt>
                <c:pt idx="29">
                  <c:v>7.1</c:v>
                </c:pt>
                <c:pt idx="30">
                  <c:v>7.056</c:v>
                </c:pt>
                <c:pt idx="31">
                  <c:v>7.0239999999999982</c:v>
                </c:pt>
                <c:pt idx="32" formatCode="General">
                  <c:v>6.9720000000000004</c:v>
                </c:pt>
                <c:pt idx="33" formatCode="General">
                  <c:v>6.9539999999999997</c:v>
                </c:pt>
                <c:pt idx="34" formatCode="General">
                  <c:v>6.9249999999999998</c:v>
                </c:pt>
                <c:pt idx="35" formatCode="General">
                  <c:v>6.8649999999999967</c:v>
                </c:pt>
                <c:pt idx="36" formatCode="General">
                  <c:v>6.8449999999999998</c:v>
                </c:pt>
                <c:pt idx="37" formatCode="General">
                  <c:v>6.7889999999999997</c:v>
                </c:pt>
                <c:pt idx="38" formatCode="General">
                  <c:v>6.7439999999999998</c:v>
                </c:pt>
                <c:pt idx="39" formatCode="General">
                  <c:v>6.7009999999999996</c:v>
                </c:pt>
                <c:pt idx="40" formatCode="General">
                  <c:v>6.6609999999999969</c:v>
                </c:pt>
                <c:pt idx="41" formatCode="General">
                  <c:v>6.6339999999999977</c:v>
                </c:pt>
                <c:pt idx="42" formatCode="General">
                  <c:v>6.6239999999999979</c:v>
                </c:pt>
                <c:pt idx="43" formatCode="General">
                  <c:v>6.5750000000000002</c:v>
                </c:pt>
                <c:pt idx="44" formatCode="General">
                  <c:v>6.5430000000000001</c:v>
                </c:pt>
                <c:pt idx="45" formatCode="General">
                  <c:v>6.5039999999999996</c:v>
                </c:pt>
                <c:pt idx="46" formatCode="General">
                  <c:v>6.4710000000000001</c:v>
                </c:pt>
                <c:pt idx="47" formatCode="General">
                  <c:v>7.4059999999999997</c:v>
                </c:pt>
                <c:pt idx="48" formatCode="General">
                  <c:v>9.3800000000000008</c:v>
                </c:pt>
                <c:pt idx="49" formatCode="General">
                  <c:v>9.3680000000000003</c:v>
                </c:pt>
                <c:pt idx="50" formatCode="General">
                  <c:v>9.2929999999999993</c:v>
                </c:pt>
                <c:pt idx="51" formatCode="General">
                  <c:v>9.2149999999999999</c:v>
                </c:pt>
                <c:pt idx="52" formatCode="General">
                  <c:v>9.1820000000000004</c:v>
                </c:pt>
                <c:pt idx="53" formatCode="General">
                  <c:v>9.1150000000000002</c:v>
                </c:pt>
                <c:pt idx="54" formatCode="General">
                  <c:v>9.0589999999999993</c:v>
                </c:pt>
                <c:pt idx="55" formatCode="General">
                  <c:v>9.0229999999999997</c:v>
                </c:pt>
                <c:pt idx="56" formatCode="General">
                  <c:v>8.9550000000000001</c:v>
                </c:pt>
                <c:pt idx="57" formatCode="General">
                  <c:v>8.9309999999999992</c:v>
                </c:pt>
                <c:pt idx="58" formatCode="General">
                  <c:v>8.907</c:v>
                </c:pt>
                <c:pt idx="59" formatCode="General">
                  <c:v>8.8620000000000001</c:v>
                </c:pt>
                <c:pt idx="60" formatCode="General">
                  <c:v>8.8119999999999994</c:v>
                </c:pt>
                <c:pt idx="61" formatCode="General">
                  <c:v>8.7650000000000006</c:v>
                </c:pt>
                <c:pt idx="62" formatCode="General">
                  <c:v>8.7420000000000009</c:v>
                </c:pt>
                <c:pt idx="63" formatCode="General">
                  <c:v>8.7050000000000001</c:v>
                </c:pt>
                <c:pt idx="64" formatCode="General">
                  <c:v>8.6379999999999999</c:v>
                </c:pt>
                <c:pt idx="65" formatCode="General">
                  <c:v>8.6329999999999991</c:v>
                </c:pt>
                <c:pt idx="66" formatCode="General">
                  <c:v>8.5909999999999993</c:v>
                </c:pt>
                <c:pt idx="67" formatCode="General">
                  <c:v>10.06</c:v>
                </c:pt>
                <c:pt idx="68" formatCode="General">
                  <c:v>11.23</c:v>
                </c:pt>
                <c:pt idx="69" formatCode="General">
                  <c:v>11.17</c:v>
                </c:pt>
                <c:pt idx="70" formatCode="General">
                  <c:v>11.13</c:v>
                </c:pt>
                <c:pt idx="71" formatCode="General">
                  <c:v>11.09</c:v>
                </c:pt>
                <c:pt idx="72" formatCode="General">
                  <c:v>11.05</c:v>
                </c:pt>
                <c:pt idx="73" formatCode="General">
                  <c:v>10.98</c:v>
                </c:pt>
                <c:pt idx="74" formatCode="General">
                  <c:v>10.91</c:v>
                </c:pt>
                <c:pt idx="75" formatCode="General">
                  <c:v>10.93</c:v>
                </c:pt>
                <c:pt idx="76" formatCode="General">
                  <c:v>10.88</c:v>
                </c:pt>
                <c:pt idx="77" formatCode="General">
                  <c:v>10.85</c:v>
                </c:pt>
                <c:pt idx="78" formatCode="General">
                  <c:v>10.8</c:v>
                </c:pt>
                <c:pt idx="79" formatCode="General">
                  <c:v>10.8</c:v>
                </c:pt>
                <c:pt idx="80" formatCode="General">
                  <c:v>10.74</c:v>
                </c:pt>
                <c:pt idx="81" formatCode="General">
                  <c:v>10.7</c:v>
                </c:pt>
                <c:pt idx="82" formatCode="General">
                  <c:v>10.66</c:v>
                </c:pt>
                <c:pt idx="83" formatCode="General">
                  <c:v>10.63</c:v>
                </c:pt>
                <c:pt idx="84" formatCode="General">
                  <c:v>10.6</c:v>
                </c:pt>
                <c:pt idx="85" formatCode="General">
                  <c:v>10.57</c:v>
                </c:pt>
                <c:pt idx="86" formatCode="General">
                  <c:v>11.83</c:v>
                </c:pt>
                <c:pt idx="87" formatCode="General">
                  <c:v>12.75</c:v>
                </c:pt>
                <c:pt idx="88" formatCode="General">
                  <c:v>12.72</c:v>
                </c:pt>
                <c:pt idx="89" formatCode="General">
                  <c:v>12.69</c:v>
                </c:pt>
                <c:pt idx="90" formatCode="General">
                  <c:v>12.67</c:v>
                </c:pt>
                <c:pt idx="91" formatCode="General">
                  <c:v>12.66</c:v>
                </c:pt>
                <c:pt idx="92" formatCode="General">
                  <c:v>12.65</c:v>
                </c:pt>
                <c:pt idx="93" formatCode="General">
                  <c:v>12.62</c:v>
                </c:pt>
                <c:pt idx="94" formatCode="General">
                  <c:v>12.6</c:v>
                </c:pt>
                <c:pt idx="95" formatCode="General">
                  <c:v>12.62</c:v>
                </c:pt>
                <c:pt idx="96" formatCode="General">
                  <c:v>12.6</c:v>
                </c:pt>
                <c:pt idx="97" formatCode="General">
                  <c:v>12.6</c:v>
                </c:pt>
                <c:pt idx="98" formatCode="General">
                  <c:v>12.59</c:v>
                </c:pt>
                <c:pt idx="99" formatCode="General">
                  <c:v>12.58</c:v>
                </c:pt>
                <c:pt idx="100" formatCode="General">
                  <c:v>12.57</c:v>
                </c:pt>
                <c:pt idx="101" formatCode="General">
                  <c:v>12.56</c:v>
                </c:pt>
                <c:pt idx="102" formatCode="General">
                  <c:v>12.57</c:v>
                </c:pt>
                <c:pt idx="103" formatCode="General">
                  <c:v>12.55</c:v>
                </c:pt>
                <c:pt idx="104" formatCode="General">
                  <c:v>12.56</c:v>
                </c:pt>
                <c:pt idx="105" formatCode="General">
                  <c:v>12.57</c:v>
                </c:pt>
                <c:pt idx="106" formatCode="General">
                  <c:v>12.58</c:v>
                </c:pt>
                <c:pt idx="107" formatCode="General">
                  <c:v>12.57</c:v>
                </c:pt>
                <c:pt idx="108" formatCode="General">
                  <c:v>12.6</c:v>
                </c:pt>
                <c:pt idx="109" formatCode="General">
                  <c:v>12.6</c:v>
                </c:pt>
                <c:pt idx="110" formatCode="General">
                  <c:v>12.62</c:v>
                </c:pt>
                <c:pt idx="111" formatCode="General">
                  <c:v>12.63</c:v>
                </c:pt>
                <c:pt idx="112" formatCode="General">
                  <c:v>12.62</c:v>
                </c:pt>
                <c:pt idx="113" formatCode="General">
                  <c:v>12.62</c:v>
                </c:pt>
                <c:pt idx="114" formatCode="General">
                  <c:v>12.64</c:v>
                </c:pt>
                <c:pt idx="115" formatCode="General">
                  <c:v>12.66</c:v>
                </c:pt>
                <c:pt idx="116" formatCode="General">
                  <c:v>12.68</c:v>
                </c:pt>
                <c:pt idx="117" formatCode="General">
                  <c:v>12.71</c:v>
                </c:pt>
                <c:pt idx="118" formatCode="General">
                  <c:v>12.72</c:v>
                </c:pt>
                <c:pt idx="119" formatCode="General">
                  <c:v>12.74</c:v>
                </c:pt>
                <c:pt idx="120" formatCode="General">
                  <c:v>12.79</c:v>
                </c:pt>
                <c:pt idx="121" formatCode="General">
                  <c:v>12.79</c:v>
                </c:pt>
                <c:pt idx="122" formatCode="General">
                  <c:v>12.81</c:v>
                </c:pt>
                <c:pt idx="123" formatCode="General">
                  <c:v>12.87</c:v>
                </c:pt>
                <c:pt idx="124" formatCode="General">
                  <c:v>12.89</c:v>
                </c:pt>
                <c:pt idx="125" formatCode="General">
                  <c:v>12.89</c:v>
                </c:pt>
                <c:pt idx="126" formatCode="General">
                  <c:v>12.92</c:v>
                </c:pt>
                <c:pt idx="127" formatCode="General">
                  <c:v>12.93</c:v>
                </c:pt>
                <c:pt idx="128" formatCode="General">
                  <c:v>12.97</c:v>
                </c:pt>
                <c:pt idx="129" formatCode="General">
                  <c:v>13.01</c:v>
                </c:pt>
                <c:pt idx="130" formatCode="General">
                  <c:v>13.01</c:v>
                </c:pt>
                <c:pt idx="131" formatCode="General">
                  <c:v>13.01</c:v>
                </c:pt>
                <c:pt idx="132" formatCode="General">
                  <c:v>13.05</c:v>
                </c:pt>
                <c:pt idx="133" formatCode="General">
                  <c:v>13.09</c:v>
                </c:pt>
                <c:pt idx="134" formatCode="General">
                  <c:v>13.1</c:v>
                </c:pt>
                <c:pt idx="135" formatCode="General">
                  <c:v>13.1</c:v>
                </c:pt>
                <c:pt idx="136" formatCode="General">
                  <c:v>13.15</c:v>
                </c:pt>
                <c:pt idx="137" formatCode="General">
                  <c:v>13.17</c:v>
                </c:pt>
                <c:pt idx="138" formatCode="General">
                  <c:v>13.18</c:v>
                </c:pt>
                <c:pt idx="139" formatCode="General">
                  <c:v>13.23</c:v>
                </c:pt>
                <c:pt idx="140" formatCode="General">
                  <c:v>13.26</c:v>
                </c:pt>
                <c:pt idx="141" formatCode="General">
                  <c:v>13.29</c:v>
                </c:pt>
                <c:pt idx="142" formatCode="General">
                  <c:v>13.31</c:v>
                </c:pt>
                <c:pt idx="143" formatCode="General">
                  <c:v>13.35</c:v>
                </c:pt>
                <c:pt idx="144" formatCode="General">
                  <c:v>13.37</c:v>
                </c:pt>
                <c:pt idx="145" formatCode="General">
                  <c:v>13.41</c:v>
                </c:pt>
                <c:pt idx="146" formatCode="General">
                  <c:v>13.43</c:v>
                </c:pt>
                <c:pt idx="147" formatCode="General">
                  <c:v>13.47</c:v>
                </c:pt>
                <c:pt idx="148" formatCode="General">
                  <c:v>13.48</c:v>
                </c:pt>
                <c:pt idx="149" formatCode="General">
                  <c:v>13.5</c:v>
                </c:pt>
                <c:pt idx="150" formatCode="General">
                  <c:v>13.52</c:v>
                </c:pt>
                <c:pt idx="151" formatCode="General">
                  <c:v>13.52</c:v>
                </c:pt>
                <c:pt idx="152" formatCode="General">
                  <c:v>13.57</c:v>
                </c:pt>
                <c:pt idx="153" formatCode="General">
                  <c:v>13.6</c:v>
                </c:pt>
                <c:pt idx="154" formatCode="General">
                  <c:v>13.61</c:v>
                </c:pt>
                <c:pt idx="155" formatCode="General">
                  <c:v>13.66</c:v>
                </c:pt>
                <c:pt idx="156" formatCode="General">
                  <c:v>13.67</c:v>
                </c:pt>
                <c:pt idx="157" formatCode="General">
                  <c:v>13.68</c:v>
                </c:pt>
                <c:pt idx="158" formatCode="General">
                  <c:v>13.68</c:v>
                </c:pt>
                <c:pt idx="159" formatCode="General">
                  <c:v>13.7</c:v>
                </c:pt>
                <c:pt idx="160" formatCode="General">
                  <c:v>13.71</c:v>
                </c:pt>
                <c:pt idx="161" formatCode="General">
                  <c:v>13.71</c:v>
                </c:pt>
                <c:pt idx="162" formatCode="General">
                  <c:v>13.76</c:v>
                </c:pt>
                <c:pt idx="163" formatCode="General">
                  <c:v>13.78</c:v>
                </c:pt>
                <c:pt idx="164" formatCode="General">
                  <c:v>13.79</c:v>
                </c:pt>
                <c:pt idx="165" formatCode="General">
                  <c:v>13.8</c:v>
                </c:pt>
                <c:pt idx="166" formatCode="General">
                  <c:v>13.81</c:v>
                </c:pt>
                <c:pt idx="167" formatCode="General">
                  <c:v>13.85</c:v>
                </c:pt>
                <c:pt idx="168" formatCode="General">
                  <c:v>13.86</c:v>
                </c:pt>
                <c:pt idx="169" formatCode="General">
                  <c:v>13.87</c:v>
                </c:pt>
                <c:pt idx="170" formatCode="General">
                  <c:v>13.91</c:v>
                </c:pt>
                <c:pt idx="171" formatCode="General">
                  <c:v>13.93</c:v>
                </c:pt>
                <c:pt idx="172" formatCode="General">
                  <c:v>13.94</c:v>
                </c:pt>
                <c:pt idx="173" formatCode="General">
                  <c:v>13.97</c:v>
                </c:pt>
                <c:pt idx="174" formatCode="General">
                  <c:v>13.96</c:v>
                </c:pt>
                <c:pt idx="175" formatCode="General">
                  <c:v>13.96</c:v>
                </c:pt>
                <c:pt idx="176" formatCode="General">
                  <c:v>13.97</c:v>
                </c:pt>
                <c:pt idx="177" formatCode="General">
                  <c:v>13.98</c:v>
                </c:pt>
                <c:pt idx="178" formatCode="General">
                  <c:v>14.01</c:v>
                </c:pt>
                <c:pt idx="179" formatCode="General">
                  <c:v>14.04</c:v>
                </c:pt>
                <c:pt idx="180" formatCode="General">
                  <c:v>14.07</c:v>
                </c:pt>
                <c:pt idx="181" formatCode="General">
                  <c:v>14.06</c:v>
                </c:pt>
                <c:pt idx="182" formatCode="General">
                  <c:v>14.07</c:v>
                </c:pt>
                <c:pt idx="183" formatCode="General">
                  <c:v>14.07</c:v>
                </c:pt>
                <c:pt idx="184" formatCode="General">
                  <c:v>14.09</c:v>
                </c:pt>
                <c:pt idx="185" formatCode="General">
                  <c:v>14.1</c:v>
                </c:pt>
                <c:pt idx="186" formatCode="General">
                  <c:v>14.11</c:v>
                </c:pt>
                <c:pt idx="187" formatCode="General">
                  <c:v>14.12</c:v>
                </c:pt>
                <c:pt idx="188" formatCode="General">
                  <c:v>14.15</c:v>
                </c:pt>
                <c:pt idx="189" formatCode="General">
                  <c:v>14.12</c:v>
                </c:pt>
                <c:pt idx="190" formatCode="General">
                  <c:v>14.17</c:v>
                </c:pt>
                <c:pt idx="191" formatCode="General">
                  <c:v>14.18</c:v>
                </c:pt>
                <c:pt idx="192" formatCode="General">
                  <c:v>14.18</c:v>
                </c:pt>
                <c:pt idx="193" formatCode="General">
                  <c:v>14.2</c:v>
                </c:pt>
                <c:pt idx="194" formatCode="General">
                  <c:v>14.21</c:v>
                </c:pt>
                <c:pt idx="195" formatCode="General">
                  <c:v>14.2</c:v>
                </c:pt>
                <c:pt idx="196" formatCode="General">
                  <c:v>14.19</c:v>
                </c:pt>
                <c:pt idx="197" formatCode="General">
                  <c:v>14.2</c:v>
                </c:pt>
                <c:pt idx="198" formatCode="General">
                  <c:v>14.23</c:v>
                </c:pt>
                <c:pt idx="199" formatCode="General">
                  <c:v>14.2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451C-FD48-BF37-2CF52A18E8C3}"/>
            </c:ext>
          </c:extLst>
        </c:ser>
        <c:ser>
          <c:idx val="3"/>
          <c:order val="3"/>
          <c:tx>
            <c:strRef>
              <c:f>Feuil1!$E$2</c:f>
              <c:strCache>
                <c:ptCount val="1"/>
              </c:strCache>
            </c:strRef>
          </c:tx>
          <c:spPr>
            <a:ln w="28575" cap="rnd" cmpd="sng">
              <a:solidFill>
                <a:srgbClr val="008000"/>
              </a:solidFill>
              <a:round/>
            </a:ln>
            <a:effectLst/>
          </c:spPr>
          <c:marker>
            <c:symbol val="none"/>
          </c:marker>
          <c:xVal>
            <c:numRef>
              <c:f>Feuil1!$A$3:$A$202</c:f>
              <c:numCache>
                <c:formatCode>0.00</c:formatCode>
                <c:ptCount val="200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  <c:pt idx="21">
                  <c:v>105</c:v>
                </c:pt>
                <c:pt idx="22">
                  <c:v>110</c:v>
                </c:pt>
                <c:pt idx="23">
                  <c:v>115</c:v>
                </c:pt>
                <c:pt idx="24">
                  <c:v>120</c:v>
                </c:pt>
                <c:pt idx="25">
                  <c:v>125</c:v>
                </c:pt>
                <c:pt idx="26">
                  <c:v>130</c:v>
                </c:pt>
                <c:pt idx="27">
                  <c:v>135</c:v>
                </c:pt>
                <c:pt idx="28">
                  <c:v>140</c:v>
                </c:pt>
                <c:pt idx="29">
                  <c:v>145</c:v>
                </c:pt>
                <c:pt idx="30">
                  <c:v>150</c:v>
                </c:pt>
                <c:pt idx="31">
                  <c:v>155</c:v>
                </c:pt>
                <c:pt idx="32" formatCode="General">
                  <c:v>160</c:v>
                </c:pt>
                <c:pt idx="33" formatCode="General">
                  <c:v>165</c:v>
                </c:pt>
                <c:pt idx="34" formatCode="General">
                  <c:v>170</c:v>
                </c:pt>
                <c:pt idx="35" formatCode="General">
                  <c:v>175</c:v>
                </c:pt>
                <c:pt idx="36" formatCode="General">
                  <c:v>180</c:v>
                </c:pt>
                <c:pt idx="37" formatCode="General">
                  <c:v>185</c:v>
                </c:pt>
                <c:pt idx="38" formatCode="General">
                  <c:v>190</c:v>
                </c:pt>
                <c:pt idx="39" formatCode="General">
                  <c:v>195</c:v>
                </c:pt>
                <c:pt idx="40" formatCode="General">
                  <c:v>200</c:v>
                </c:pt>
                <c:pt idx="41" formatCode="General">
                  <c:v>205</c:v>
                </c:pt>
                <c:pt idx="42" formatCode="General">
                  <c:v>210</c:v>
                </c:pt>
                <c:pt idx="43" formatCode="General">
                  <c:v>215</c:v>
                </c:pt>
                <c:pt idx="44" formatCode="General">
                  <c:v>220</c:v>
                </c:pt>
                <c:pt idx="45" formatCode="General">
                  <c:v>225</c:v>
                </c:pt>
                <c:pt idx="46" formatCode="General">
                  <c:v>230</c:v>
                </c:pt>
                <c:pt idx="47" formatCode="General">
                  <c:v>235</c:v>
                </c:pt>
                <c:pt idx="48" formatCode="General">
                  <c:v>240</c:v>
                </c:pt>
                <c:pt idx="49" formatCode="General">
                  <c:v>245</c:v>
                </c:pt>
                <c:pt idx="50" formatCode="General">
                  <c:v>250</c:v>
                </c:pt>
                <c:pt idx="51" formatCode="General">
                  <c:v>255</c:v>
                </c:pt>
                <c:pt idx="52" formatCode="General">
                  <c:v>260</c:v>
                </c:pt>
                <c:pt idx="53" formatCode="General">
                  <c:v>265</c:v>
                </c:pt>
                <c:pt idx="54" formatCode="General">
                  <c:v>270</c:v>
                </c:pt>
                <c:pt idx="55" formatCode="General">
                  <c:v>275</c:v>
                </c:pt>
                <c:pt idx="56" formatCode="General">
                  <c:v>280</c:v>
                </c:pt>
                <c:pt idx="57" formatCode="General">
                  <c:v>285</c:v>
                </c:pt>
                <c:pt idx="58" formatCode="General">
                  <c:v>290</c:v>
                </c:pt>
                <c:pt idx="59" formatCode="General">
                  <c:v>295</c:v>
                </c:pt>
                <c:pt idx="60" formatCode="General">
                  <c:v>300</c:v>
                </c:pt>
                <c:pt idx="61" formatCode="General">
                  <c:v>305</c:v>
                </c:pt>
                <c:pt idx="62" formatCode="General">
                  <c:v>310</c:v>
                </c:pt>
                <c:pt idx="63" formatCode="General">
                  <c:v>315</c:v>
                </c:pt>
                <c:pt idx="64" formatCode="General">
                  <c:v>320</c:v>
                </c:pt>
                <c:pt idx="65" formatCode="General">
                  <c:v>325</c:v>
                </c:pt>
                <c:pt idx="66" formatCode="General">
                  <c:v>330</c:v>
                </c:pt>
                <c:pt idx="67" formatCode="General">
                  <c:v>335</c:v>
                </c:pt>
                <c:pt idx="68" formatCode="General">
                  <c:v>340</c:v>
                </c:pt>
                <c:pt idx="69" formatCode="General">
                  <c:v>345</c:v>
                </c:pt>
                <c:pt idx="70" formatCode="General">
                  <c:v>350</c:v>
                </c:pt>
                <c:pt idx="71" formatCode="General">
                  <c:v>355</c:v>
                </c:pt>
                <c:pt idx="72" formatCode="General">
                  <c:v>360</c:v>
                </c:pt>
                <c:pt idx="73" formatCode="General">
                  <c:v>365</c:v>
                </c:pt>
                <c:pt idx="74" formatCode="General">
                  <c:v>370</c:v>
                </c:pt>
                <c:pt idx="75" formatCode="General">
                  <c:v>375</c:v>
                </c:pt>
                <c:pt idx="76" formatCode="General">
                  <c:v>380</c:v>
                </c:pt>
                <c:pt idx="77" formatCode="General">
                  <c:v>385</c:v>
                </c:pt>
                <c:pt idx="78" formatCode="General">
                  <c:v>390</c:v>
                </c:pt>
                <c:pt idx="79" formatCode="General">
                  <c:v>395</c:v>
                </c:pt>
                <c:pt idx="80" formatCode="General">
                  <c:v>400</c:v>
                </c:pt>
                <c:pt idx="81" formatCode="General">
                  <c:v>405</c:v>
                </c:pt>
                <c:pt idx="82" formatCode="General">
                  <c:v>410</c:v>
                </c:pt>
                <c:pt idx="83" formatCode="General">
                  <c:v>415</c:v>
                </c:pt>
                <c:pt idx="84" formatCode="General">
                  <c:v>420</c:v>
                </c:pt>
                <c:pt idx="85" formatCode="General">
                  <c:v>425</c:v>
                </c:pt>
                <c:pt idx="86" formatCode="General">
                  <c:v>430</c:v>
                </c:pt>
                <c:pt idx="87" formatCode="General">
                  <c:v>435</c:v>
                </c:pt>
                <c:pt idx="88" formatCode="General">
                  <c:v>440</c:v>
                </c:pt>
                <c:pt idx="89" formatCode="General">
                  <c:v>445</c:v>
                </c:pt>
                <c:pt idx="90" formatCode="General">
                  <c:v>450</c:v>
                </c:pt>
                <c:pt idx="91" formatCode="General">
                  <c:v>455</c:v>
                </c:pt>
                <c:pt idx="92" formatCode="General">
                  <c:v>460</c:v>
                </c:pt>
                <c:pt idx="93" formatCode="General">
                  <c:v>465</c:v>
                </c:pt>
                <c:pt idx="94" formatCode="General">
                  <c:v>470</c:v>
                </c:pt>
                <c:pt idx="95" formatCode="General">
                  <c:v>475</c:v>
                </c:pt>
                <c:pt idx="96" formatCode="General">
                  <c:v>480</c:v>
                </c:pt>
                <c:pt idx="97" formatCode="General">
                  <c:v>485</c:v>
                </c:pt>
                <c:pt idx="98" formatCode="General">
                  <c:v>490</c:v>
                </c:pt>
                <c:pt idx="99" formatCode="General">
                  <c:v>495</c:v>
                </c:pt>
                <c:pt idx="100" formatCode="General">
                  <c:v>500</c:v>
                </c:pt>
                <c:pt idx="101" formatCode="General">
                  <c:v>505</c:v>
                </c:pt>
                <c:pt idx="102" formatCode="General">
                  <c:v>510</c:v>
                </c:pt>
                <c:pt idx="103" formatCode="General">
                  <c:v>515</c:v>
                </c:pt>
                <c:pt idx="104" formatCode="General">
                  <c:v>520</c:v>
                </c:pt>
                <c:pt idx="105" formatCode="General">
                  <c:v>525</c:v>
                </c:pt>
                <c:pt idx="106" formatCode="General">
                  <c:v>530</c:v>
                </c:pt>
                <c:pt idx="107" formatCode="General">
                  <c:v>535</c:v>
                </c:pt>
                <c:pt idx="108" formatCode="General">
                  <c:v>540</c:v>
                </c:pt>
                <c:pt idx="109" formatCode="General">
                  <c:v>545</c:v>
                </c:pt>
                <c:pt idx="110" formatCode="General">
                  <c:v>550</c:v>
                </c:pt>
                <c:pt idx="111" formatCode="General">
                  <c:v>555</c:v>
                </c:pt>
                <c:pt idx="112" formatCode="General">
                  <c:v>560</c:v>
                </c:pt>
                <c:pt idx="113" formatCode="General">
                  <c:v>565</c:v>
                </c:pt>
                <c:pt idx="114" formatCode="General">
                  <c:v>570</c:v>
                </c:pt>
                <c:pt idx="115" formatCode="General">
                  <c:v>575</c:v>
                </c:pt>
                <c:pt idx="116" formatCode="General">
                  <c:v>580</c:v>
                </c:pt>
                <c:pt idx="117" formatCode="General">
                  <c:v>585</c:v>
                </c:pt>
                <c:pt idx="118" formatCode="General">
                  <c:v>590</c:v>
                </c:pt>
                <c:pt idx="119" formatCode="General">
                  <c:v>595</c:v>
                </c:pt>
                <c:pt idx="120" formatCode="General">
                  <c:v>600</c:v>
                </c:pt>
                <c:pt idx="121" formatCode="General">
                  <c:v>605</c:v>
                </c:pt>
                <c:pt idx="122" formatCode="General">
                  <c:v>610</c:v>
                </c:pt>
                <c:pt idx="123" formatCode="General">
                  <c:v>615</c:v>
                </c:pt>
                <c:pt idx="124" formatCode="General">
                  <c:v>620</c:v>
                </c:pt>
                <c:pt idx="125" formatCode="General">
                  <c:v>625</c:v>
                </c:pt>
                <c:pt idx="126" formatCode="General">
                  <c:v>630</c:v>
                </c:pt>
                <c:pt idx="127" formatCode="General">
                  <c:v>635</c:v>
                </c:pt>
                <c:pt idx="128" formatCode="General">
                  <c:v>640</c:v>
                </c:pt>
                <c:pt idx="129" formatCode="General">
                  <c:v>645</c:v>
                </c:pt>
                <c:pt idx="130" formatCode="General">
                  <c:v>650</c:v>
                </c:pt>
                <c:pt idx="131" formatCode="General">
                  <c:v>655</c:v>
                </c:pt>
                <c:pt idx="132" formatCode="General">
                  <c:v>660</c:v>
                </c:pt>
                <c:pt idx="133" formatCode="General">
                  <c:v>665</c:v>
                </c:pt>
                <c:pt idx="134" formatCode="General">
                  <c:v>670</c:v>
                </c:pt>
                <c:pt idx="135" formatCode="General">
                  <c:v>675</c:v>
                </c:pt>
                <c:pt idx="136" formatCode="General">
                  <c:v>680</c:v>
                </c:pt>
                <c:pt idx="137" formatCode="General">
                  <c:v>685</c:v>
                </c:pt>
                <c:pt idx="138" formatCode="General">
                  <c:v>690</c:v>
                </c:pt>
                <c:pt idx="139" formatCode="General">
                  <c:v>695</c:v>
                </c:pt>
                <c:pt idx="140" formatCode="General">
                  <c:v>700</c:v>
                </c:pt>
                <c:pt idx="141" formatCode="General">
                  <c:v>705</c:v>
                </c:pt>
                <c:pt idx="142" formatCode="General">
                  <c:v>710</c:v>
                </c:pt>
                <c:pt idx="143" formatCode="General">
                  <c:v>715</c:v>
                </c:pt>
                <c:pt idx="144" formatCode="General">
                  <c:v>720</c:v>
                </c:pt>
                <c:pt idx="145" formatCode="General">
                  <c:v>725</c:v>
                </c:pt>
                <c:pt idx="146" formatCode="General">
                  <c:v>730</c:v>
                </c:pt>
                <c:pt idx="147" formatCode="General">
                  <c:v>735</c:v>
                </c:pt>
                <c:pt idx="148" formatCode="General">
                  <c:v>740</c:v>
                </c:pt>
                <c:pt idx="149" formatCode="General">
                  <c:v>745</c:v>
                </c:pt>
                <c:pt idx="150" formatCode="General">
                  <c:v>750</c:v>
                </c:pt>
                <c:pt idx="151" formatCode="General">
                  <c:v>755</c:v>
                </c:pt>
                <c:pt idx="152" formatCode="General">
                  <c:v>760</c:v>
                </c:pt>
                <c:pt idx="153" formatCode="General">
                  <c:v>765</c:v>
                </c:pt>
                <c:pt idx="154" formatCode="General">
                  <c:v>770</c:v>
                </c:pt>
                <c:pt idx="155" formatCode="General">
                  <c:v>775</c:v>
                </c:pt>
                <c:pt idx="156" formatCode="General">
                  <c:v>780</c:v>
                </c:pt>
                <c:pt idx="157" formatCode="General">
                  <c:v>785</c:v>
                </c:pt>
                <c:pt idx="158" formatCode="General">
                  <c:v>790</c:v>
                </c:pt>
                <c:pt idx="159" formatCode="General">
                  <c:v>795</c:v>
                </c:pt>
                <c:pt idx="160" formatCode="General">
                  <c:v>800</c:v>
                </c:pt>
                <c:pt idx="161" formatCode="General">
                  <c:v>805</c:v>
                </c:pt>
                <c:pt idx="162" formatCode="General">
                  <c:v>810</c:v>
                </c:pt>
                <c:pt idx="163" formatCode="General">
                  <c:v>815</c:v>
                </c:pt>
                <c:pt idx="164" formatCode="General">
                  <c:v>820</c:v>
                </c:pt>
                <c:pt idx="165" formatCode="General">
                  <c:v>825</c:v>
                </c:pt>
                <c:pt idx="166" formatCode="General">
                  <c:v>830</c:v>
                </c:pt>
                <c:pt idx="167" formatCode="General">
                  <c:v>835</c:v>
                </c:pt>
                <c:pt idx="168" formatCode="General">
                  <c:v>840</c:v>
                </c:pt>
                <c:pt idx="169" formatCode="General">
                  <c:v>845</c:v>
                </c:pt>
                <c:pt idx="170" formatCode="General">
                  <c:v>850</c:v>
                </c:pt>
                <c:pt idx="171" formatCode="General">
                  <c:v>855</c:v>
                </c:pt>
                <c:pt idx="172" formatCode="General">
                  <c:v>860</c:v>
                </c:pt>
                <c:pt idx="173" formatCode="General">
                  <c:v>865</c:v>
                </c:pt>
                <c:pt idx="174" formatCode="General">
                  <c:v>870</c:v>
                </c:pt>
                <c:pt idx="175" formatCode="General">
                  <c:v>875</c:v>
                </c:pt>
                <c:pt idx="176" formatCode="General">
                  <c:v>880</c:v>
                </c:pt>
                <c:pt idx="177" formatCode="General">
                  <c:v>885</c:v>
                </c:pt>
                <c:pt idx="178" formatCode="General">
                  <c:v>890</c:v>
                </c:pt>
                <c:pt idx="179" formatCode="General">
                  <c:v>895</c:v>
                </c:pt>
                <c:pt idx="180" formatCode="General">
                  <c:v>900</c:v>
                </c:pt>
                <c:pt idx="181" formatCode="General">
                  <c:v>905</c:v>
                </c:pt>
                <c:pt idx="182" formatCode="General">
                  <c:v>910</c:v>
                </c:pt>
                <c:pt idx="183" formatCode="General">
                  <c:v>915</c:v>
                </c:pt>
                <c:pt idx="184" formatCode="General">
                  <c:v>920</c:v>
                </c:pt>
                <c:pt idx="185" formatCode="General">
                  <c:v>925</c:v>
                </c:pt>
                <c:pt idx="186" formatCode="General">
                  <c:v>930</c:v>
                </c:pt>
                <c:pt idx="187" formatCode="General">
                  <c:v>935</c:v>
                </c:pt>
                <c:pt idx="188" formatCode="General">
                  <c:v>940</c:v>
                </c:pt>
                <c:pt idx="189" formatCode="General">
                  <c:v>945</c:v>
                </c:pt>
                <c:pt idx="190" formatCode="General">
                  <c:v>950</c:v>
                </c:pt>
                <c:pt idx="191" formatCode="General">
                  <c:v>955</c:v>
                </c:pt>
                <c:pt idx="192" formatCode="General">
                  <c:v>960</c:v>
                </c:pt>
                <c:pt idx="193" formatCode="General">
                  <c:v>965</c:v>
                </c:pt>
                <c:pt idx="194" formatCode="General">
                  <c:v>970</c:v>
                </c:pt>
                <c:pt idx="195" formatCode="General">
                  <c:v>975</c:v>
                </c:pt>
                <c:pt idx="196" formatCode="General">
                  <c:v>980</c:v>
                </c:pt>
                <c:pt idx="197" formatCode="General">
                  <c:v>985</c:v>
                </c:pt>
                <c:pt idx="198" formatCode="General">
                  <c:v>990</c:v>
                </c:pt>
                <c:pt idx="199" formatCode="General">
                  <c:v>995</c:v>
                </c:pt>
              </c:numCache>
            </c:numRef>
          </c:xVal>
          <c:yVal>
            <c:numRef>
              <c:f>Feuil1!$E$3:$E$202</c:f>
              <c:numCache>
                <c:formatCode>0.00</c:formatCode>
                <c:ptCount val="200"/>
                <c:pt idx="0">
                  <c:v>3.3610000000000002</c:v>
                </c:pt>
                <c:pt idx="1">
                  <c:v>3.35</c:v>
                </c:pt>
                <c:pt idx="2">
                  <c:v>3.3420000000000001</c:v>
                </c:pt>
                <c:pt idx="3">
                  <c:v>3.3380000000000001</c:v>
                </c:pt>
                <c:pt idx="4">
                  <c:v>3.35</c:v>
                </c:pt>
                <c:pt idx="5">
                  <c:v>3.3849999999999998</c:v>
                </c:pt>
                <c:pt idx="6">
                  <c:v>3.3389999999999991</c:v>
                </c:pt>
                <c:pt idx="7">
                  <c:v>3.3540000000000001</c:v>
                </c:pt>
                <c:pt idx="8">
                  <c:v>3.3389999999999991</c:v>
                </c:pt>
                <c:pt idx="9">
                  <c:v>3.3330000000000002</c:v>
                </c:pt>
                <c:pt idx="10">
                  <c:v>3.3540000000000001</c:v>
                </c:pt>
                <c:pt idx="11">
                  <c:v>3.3309999999999991</c:v>
                </c:pt>
                <c:pt idx="12">
                  <c:v>3.3239999999999998</c:v>
                </c:pt>
                <c:pt idx="13">
                  <c:v>3.2959999999999998</c:v>
                </c:pt>
                <c:pt idx="14">
                  <c:v>3.3069999999999999</c:v>
                </c:pt>
                <c:pt idx="15">
                  <c:v>3.27</c:v>
                </c:pt>
                <c:pt idx="16">
                  <c:v>3.2730000000000001</c:v>
                </c:pt>
                <c:pt idx="17">
                  <c:v>3.2749999999999999</c:v>
                </c:pt>
                <c:pt idx="18">
                  <c:v>3.282</c:v>
                </c:pt>
                <c:pt idx="19">
                  <c:v>3.3090000000000002</c:v>
                </c:pt>
                <c:pt idx="20">
                  <c:v>3.298</c:v>
                </c:pt>
                <c:pt idx="21">
                  <c:v>3.3069999999999999</c:v>
                </c:pt>
                <c:pt idx="22">
                  <c:v>3.2949999999999999</c:v>
                </c:pt>
                <c:pt idx="23">
                  <c:v>3.3380000000000001</c:v>
                </c:pt>
                <c:pt idx="24">
                  <c:v>7.23</c:v>
                </c:pt>
                <c:pt idx="25">
                  <c:v>7.2930000000000001</c:v>
                </c:pt>
                <c:pt idx="26">
                  <c:v>7.2069999999999999</c:v>
                </c:pt>
                <c:pt idx="27">
                  <c:v>7.1159999999999997</c:v>
                </c:pt>
                <c:pt idx="28">
                  <c:v>7.008</c:v>
                </c:pt>
                <c:pt idx="29">
                  <c:v>6.923</c:v>
                </c:pt>
                <c:pt idx="30">
                  <c:v>6.8719999999999999</c:v>
                </c:pt>
                <c:pt idx="31">
                  <c:v>6.7960000000000003</c:v>
                </c:pt>
                <c:pt idx="32" formatCode="General">
                  <c:v>6.76</c:v>
                </c:pt>
                <c:pt idx="33" formatCode="General">
                  <c:v>6.6689999999999969</c:v>
                </c:pt>
                <c:pt idx="34" formatCode="General">
                  <c:v>6.6099999999999977</c:v>
                </c:pt>
                <c:pt idx="35" formatCode="General">
                  <c:v>6.5410000000000004</c:v>
                </c:pt>
                <c:pt idx="36" formatCode="General">
                  <c:v>6.4829999999999997</c:v>
                </c:pt>
                <c:pt idx="37" formatCode="General">
                  <c:v>6.4340000000000002</c:v>
                </c:pt>
                <c:pt idx="38" formatCode="General">
                  <c:v>6.3959999999999999</c:v>
                </c:pt>
                <c:pt idx="39" formatCode="General">
                  <c:v>6.3129999999999997</c:v>
                </c:pt>
                <c:pt idx="40" formatCode="General">
                  <c:v>6.2629999999999999</c:v>
                </c:pt>
                <c:pt idx="41" formatCode="General">
                  <c:v>6.2439999999999998</c:v>
                </c:pt>
                <c:pt idx="42" formatCode="General">
                  <c:v>6.1979999999999977</c:v>
                </c:pt>
                <c:pt idx="43" formatCode="General">
                  <c:v>6.1130000000000004</c:v>
                </c:pt>
                <c:pt idx="44" formatCode="General">
                  <c:v>6.0309999999999997</c:v>
                </c:pt>
                <c:pt idx="45" formatCode="General">
                  <c:v>8.8219999999999992</c:v>
                </c:pt>
                <c:pt idx="46" formatCode="General">
                  <c:v>9.0830000000000002</c:v>
                </c:pt>
                <c:pt idx="47" formatCode="General">
                  <c:v>8.9280000000000008</c:v>
                </c:pt>
                <c:pt idx="48" formatCode="General">
                  <c:v>8.8040000000000003</c:v>
                </c:pt>
                <c:pt idx="49" formatCode="General">
                  <c:v>8.7140000000000004</c:v>
                </c:pt>
                <c:pt idx="50" formatCode="General">
                  <c:v>8.6080000000000005</c:v>
                </c:pt>
                <c:pt idx="51" formatCode="General">
                  <c:v>8.4930000000000003</c:v>
                </c:pt>
                <c:pt idx="52" formatCode="General">
                  <c:v>8.3930000000000007</c:v>
                </c:pt>
                <c:pt idx="53" formatCode="General">
                  <c:v>8.3529999999999998</c:v>
                </c:pt>
                <c:pt idx="54" formatCode="General">
                  <c:v>8.2729999999999997</c:v>
                </c:pt>
                <c:pt idx="55" formatCode="General">
                  <c:v>8.1880000000000006</c:v>
                </c:pt>
                <c:pt idx="56" formatCode="General">
                  <c:v>8.0869999999999997</c:v>
                </c:pt>
                <c:pt idx="57" formatCode="General">
                  <c:v>7.9870000000000001</c:v>
                </c:pt>
                <c:pt idx="58" formatCode="General">
                  <c:v>7.8780000000000001</c:v>
                </c:pt>
                <c:pt idx="59" formatCode="General">
                  <c:v>7.7699999999999987</c:v>
                </c:pt>
                <c:pt idx="60" formatCode="General">
                  <c:v>7.7450000000000001</c:v>
                </c:pt>
                <c:pt idx="61" formatCode="General">
                  <c:v>7.7069999999999999</c:v>
                </c:pt>
                <c:pt idx="62" formatCode="General">
                  <c:v>7.6049999999999978</c:v>
                </c:pt>
                <c:pt idx="63" formatCode="General">
                  <c:v>8.1159999999999997</c:v>
                </c:pt>
                <c:pt idx="64" formatCode="General">
                  <c:v>10.38</c:v>
                </c:pt>
                <c:pt idx="65" formatCode="General">
                  <c:v>10.25</c:v>
                </c:pt>
                <c:pt idx="66" formatCode="General">
                  <c:v>10.050000000000001</c:v>
                </c:pt>
                <c:pt idx="67" formatCode="General">
                  <c:v>9.9049999999999994</c:v>
                </c:pt>
                <c:pt idx="68" formatCode="General">
                  <c:v>9.8130000000000006</c:v>
                </c:pt>
                <c:pt idx="69" formatCode="General">
                  <c:v>9.6669999999999998</c:v>
                </c:pt>
                <c:pt idx="70" formatCode="General">
                  <c:v>9.5210000000000008</c:v>
                </c:pt>
                <c:pt idx="71" formatCode="General">
                  <c:v>9.407</c:v>
                </c:pt>
                <c:pt idx="72" formatCode="General">
                  <c:v>9.327</c:v>
                </c:pt>
                <c:pt idx="73" formatCode="General">
                  <c:v>9.2319999999999993</c:v>
                </c:pt>
                <c:pt idx="74" formatCode="General">
                  <c:v>9.15</c:v>
                </c:pt>
                <c:pt idx="75" formatCode="General">
                  <c:v>9.0419999999999998</c:v>
                </c:pt>
                <c:pt idx="76" formatCode="General">
                  <c:v>8.9369999999999994</c:v>
                </c:pt>
                <c:pt idx="77" formatCode="General">
                  <c:v>8.8680000000000003</c:v>
                </c:pt>
                <c:pt idx="78" formatCode="General">
                  <c:v>8.7520000000000007</c:v>
                </c:pt>
                <c:pt idx="79" formatCode="General">
                  <c:v>8.6389999999999993</c:v>
                </c:pt>
                <c:pt idx="80" formatCode="General">
                  <c:v>8.5169999999999995</c:v>
                </c:pt>
                <c:pt idx="81" formatCode="General">
                  <c:v>8.4700000000000006</c:v>
                </c:pt>
                <c:pt idx="82" formatCode="General">
                  <c:v>9.5570000000000004</c:v>
                </c:pt>
                <c:pt idx="83" formatCode="General">
                  <c:v>10.89</c:v>
                </c:pt>
                <c:pt idx="84" formatCode="General">
                  <c:v>10.76</c:v>
                </c:pt>
                <c:pt idx="85" formatCode="General">
                  <c:v>10.62</c:v>
                </c:pt>
                <c:pt idx="86" formatCode="General">
                  <c:v>10.52</c:v>
                </c:pt>
                <c:pt idx="87" formatCode="General">
                  <c:v>10.41</c:v>
                </c:pt>
                <c:pt idx="88" formatCode="General">
                  <c:v>10.26</c:v>
                </c:pt>
                <c:pt idx="89" formatCode="General">
                  <c:v>10.19</c:v>
                </c:pt>
                <c:pt idx="90" formatCode="General">
                  <c:v>10.09</c:v>
                </c:pt>
                <c:pt idx="91" formatCode="General">
                  <c:v>9.9649999999999999</c:v>
                </c:pt>
                <c:pt idx="92" formatCode="General">
                  <c:v>9.8539999999999992</c:v>
                </c:pt>
                <c:pt idx="93" formatCode="General">
                  <c:v>9.7759999999999998</c:v>
                </c:pt>
                <c:pt idx="94" formatCode="General">
                  <c:v>9.6869999999999994</c:v>
                </c:pt>
                <c:pt idx="95" formatCode="General">
                  <c:v>9.5640000000000001</c:v>
                </c:pt>
                <c:pt idx="96" formatCode="General">
                  <c:v>9.452</c:v>
                </c:pt>
                <c:pt idx="97" formatCode="General">
                  <c:v>9.3979999999999997</c:v>
                </c:pt>
                <c:pt idx="98" formatCode="General">
                  <c:v>9.3230000000000004</c:v>
                </c:pt>
                <c:pt idx="99" formatCode="General">
                  <c:v>9.2200000000000006</c:v>
                </c:pt>
                <c:pt idx="100" formatCode="General">
                  <c:v>9.1359999999999992</c:v>
                </c:pt>
                <c:pt idx="101" formatCode="General">
                  <c:v>10.58</c:v>
                </c:pt>
                <c:pt idx="102" formatCode="General">
                  <c:v>11.45</c:v>
                </c:pt>
                <c:pt idx="103" formatCode="General">
                  <c:v>11.3</c:v>
                </c:pt>
                <c:pt idx="104" formatCode="General">
                  <c:v>11.19</c:v>
                </c:pt>
                <c:pt idx="105" formatCode="General">
                  <c:v>11.06</c:v>
                </c:pt>
                <c:pt idx="106" formatCode="General">
                  <c:v>10.99</c:v>
                </c:pt>
                <c:pt idx="107" formatCode="General">
                  <c:v>10.93</c:v>
                </c:pt>
                <c:pt idx="108" formatCode="General">
                  <c:v>10.79</c:v>
                </c:pt>
                <c:pt idx="109" formatCode="General">
                  <c:v>10.73</c:v>
                </c:pt>
                <c:pt idx="110" formatCode="General">
                  <c:v>10.66</c:v>
                </c:pt>
                <c:pt idx="111" formatCode="General">
                  <c:v>10.55</c:v>
                </c:pt>
                <c:pt idx="112" formatCode="General">
                  <c:v>10.49</c:v>
                </c:pt>
                <c:pt idx="113" formatCode="General">
                  <c:v>10.41</c:v>
                </c:pt>
                <c:pt idx="114" formatCode="General">
                  <c:v>10.37</c:v>
                </c:pt>
                <c:pt idx="115" formatCode="General">
                  <c:v>10.32</c:v>
                </c:pt>
                <c:pt idx="116" formatCode="General">
                  <c:v>10.25</c:v>
                </c:pt>
                <c:pt idx="117" formatCode="General">
                  <c:v>10.25</c:v>
                </c:pt>
                <c:pt idx="118" formatCode="General">
                  <c:v>10.210000000000001</c:v>
                </c:pt>
                <c:pt idx="119" formatCode="General">
                  <c:v>10.07</c:v>
                </c:pt>
                <c:pt idx="120" formatCode="General">
                  <c:v>11.9</c:v>
                </c:pt>
                <c:pt idx="121" formatCode="General">
                  <c:v>12.23</c:v>
                </c:pt>
                <c:pt idx="122" formatCode="General">
                  <c:v>12.18</c:v>
                </c:pt>
                <c:pt idx="123" formatCode="General">
                  <c:v>12.11</c:v>
                </c:pt>
                <c:pt idx="124" formatCode="General">
                  <c:v>12.06</c:v>
                </c:pt>
                <c:pt idx="125" formatCode="General">
                  <c:v>11.93</c:v>
                </c:pt>
                <c:pt idx="126" formatCode="General">
                  <c:v>11.88</c:v>
                </c:pt>
                <c:pt idx="127" formatCode="General">
                  <c:v>11.84</c:v>
                </c:pt>
                <c:pt idx="128" formatCode="General">
                  <c:v>11.8</c:v>
                </c:pt>
                <c:pt idx="129" formatCode="General">
                  <c:v>11.75</c:v>
                </c:pt>
                <c:pt idx="130" formatCode="General">
                  <c:v>11.71</c:v>
                </c:pt>
                <c:pt idx="131" formatCode="General">
                  <c:v>11.68</c:v>
                </c:pt>
                <c:pt idx="132" formatCode="General">
                  <c:v>11.66</c:v>
                </c:pt>
                <c:pt idx="133" formatCode="General">
                  <c:v>11.6</c:v>
                </c:pt>
                <c:pt idx="134" formatCode="General">
                  <c:v>11.54</c:v>
                </c:pt>
                <c:pt idx="135" formatCode="General">
                  <c:v>11.53</c:v>
                </c:pt>
                <c:pt idx="136" formatCode="General">
                  <c:v>11.48</c:v>
                </c:pt>
                <c:pt idx="137" formatCode="General">
                  <c:v>11.44</c:v>
                </c:pt>
                <c:pt idx="138" formatCode="General">
                  <c:v>11.47</c:v>
                </c:pt>
                <c:pt idx="139" formatCode="General">
                  <c:v>12.45</c:v>
                </c:pt>
                <c:pt idx="140" formatCode="General">
                  <c:v>13.34</c:v>
                </c:pt>
                <c:pt idx="141" formatCode="General">
                  <c:v>13.34</c:v>
                </c:pt>
                <c:pt idx="142" formatCode="General">
                  <c:v>13.33</c:v>
                </c:pt>
                <c:pt idx="143" formatCode="General">
                  <c:v>13.29</c:v>
                </c:pt>
                <c:pt idx="144" formatCode="General">
                  <c:v>13.28</c:v>
                </c:pt>
                <c:pt idx="145" formatCode="General">
                  <c:v>13.27</c:v>
                </c:pt>
                <c:pt idx="146" formatCode="General">
                  <c:v>13.2</c:v>
                </c:pt>
                <c:pt idx="147" formatCode="General">
                  <c:v>13.16</c:v>
                </c:pt>
                <c:pt idx="148" formatCode="General">
                  <c:v>13.16</c:v>
                </c:pt>
                <c:pt idx="149" formatCode="General">
                  <c:v>13.17</c:v>
                </c:pt>
                <c:pt idx="150" formatCode="General">
                  <c:v>13.15</c:v>
                </c:pt>
                <c:pt idx="151" formatCode="General">
                  <c:v>13.16</c:v>
                </c:pt>
                <c:pt idx="152" formatCode="General">
                  <c:v>13.17</c:v>
                </c:pt>
                <c:pt idx="153" formatCode="General">
                  <c:v>13.19</c:v>
                </c:pt>
                <c:pt idx="154" formatCode="General">
                  <c:v>13.22</c:v>
                </c:pt>
                <c:pt idx="155" formatCode="General">
                  <c:v>13.19</c:v>
                </c:pt>
                <c:pt idx="156" formatCode="General">
                  <c:v>13.24</c:v>
                </c:pt>
                <c:pt idx="157" formatCode="General">
                  <c:v>13.26</c:v>
                </c:pt>
                <c:pt idx="158" formatCode="General">
                  <c:v>13.23</c:v>
                </c:pt>
                <c:pt idx="159" formatCode="General">
                  <c:v>13.27</c:v>
                </c:pt>
                <c:pt idx="160" formatCode="General">
                  <c:v>13.31</c:v>
                </c:pt>
                <c:pt idx="161" formatCode="General">
                  <c:v>13.32</c:v>
                </c:pt>
                <c:pt idx="162" formatCode="General">
                  <c:v>13.34</c:v>
                </c:pt>
                <c:pt idx="163" formatCode="General">
                  <c:v>13.39</c:v>
                </c:pt>
                <c:pt idx="164" formatCode="General">
                  <c:v>13.4</c:v>
                </c:pt>
                <c:pt idx="165" formatCode="General">
                  <c:v>13.42</c:v>
                </c:pt>
                <c:pt idx="166" formatCode="General">
                  <c:v>13.47</c:v>
                </c:pt>
                <c:pt idx="167" formatCode="General">
                  <c:v>13.5</c:v>
                </c:pt>
                <c:pt idx="168" formatCode="General">
                  <c:v>13.51</c:v>
                </c:pt>
                <c:pt idx="169" formatCode="General">
                  <c:v>13.57</c:v>
                </c:pt>
                <c:pt idx="170" formatCode="General">
                  <c:v>13.57</c:v>
                </c:pt>
                <c:pt idx="171" formatCode="General">
                  <c:v>13.65</c:v>
                </c:pt>
                <c:pt idx="172" formatCode="General">
                  <c:v>13.66</c:v>
                </c:pt>
                <c:pt idx="173" formatCode="General">
                  <c:v>13.72</c:v>
                </c:pt>
                <c:pt idx="174" formatCode="General">
                  <c:v>13.72</c:v>
                </c:pt>
                <c:pt idx="175" formatCode="General">
                  <c:v>13.78</c:v>
                </c:pt>
                <c:pt idx="176" formatCode="General">
                  <c:v>13.83</c:v>
                </c:pt>
                <c:pt idx="177" formatCode="General">
                  <c:v>13.86</c:v>
                </c:pt>
                <c:pt idx="178" formatCode="General">
                  <c:v>13.91</c:v>
                </c:pt>
                <c:pt idx="179" formatCode="General">
                  <c:v>13.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451C-FD48-BF37-2CF52A18E8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3825880"/>
        <c:axId val="2133831560"/>
      </c:scatterChart>
      <c:valAx>
        <c:axId val="2133825880"/>
        <c:scaling>
          <c:orientation val="minMax"/>
          <c:max val="10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rgbClr val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600" b="1">
                    <a:solidFill>
                      <a:srgbClr val="000000"/>
                    </a:solidFill>
                  </a:rPr>
                  <a:t>Time (sec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3831560"/>
        <c:crosses val="autoZero"/>
        <c:crossBetween val="midCat"/>
      </c:valAx>
      <c:valAx>
        <c:axId val="2133831560"/>
        <c:scaling>
          <c:orientation val="minMax"/>
          <c:max val="2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600" b="1">
                    <a:solidFill>
                      <a:schemeClr val="tx1"/>
                    </a:solidFill>
                  </a:rPr>
                  <a:t>Extra-mitochondrial</a:t>
                </a:r>
                <a:r>
                  <a:rPr lang="fr-FR" sz="1600" b="1" baseline="0">
                    <a:solidFill>
                      <a:schemeClr val="tx1"/>
                    </a:solidFill>
                  </a:rPr>
                  <a:t> Ca</a:t>
                </a:r>
                <a:r>
                  <a:rPr lang="fr-FR" sz="1600" b="1" baseline="30000">
                    <a:solidFill>
                      <a:schemeClr val="tx1"/>
                    </a:solidFill>
                  </a:rPr>
                  <a:t>2+ </a:t>
                </a:r>
                <a:r>
                  <a:rPr lang="fr-FR" sz="1600" b="1" baseline="0">
                    <a:solidFill>
                      <a:schemeClr val="tx1"/>
                    </a:solidFill>
                  </a:rPr>
                  <a:t>F (A.U.)</a:t>
                </a:r>
                <a:endParaRPr lang="fr-FR" sz="1600" b="1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3825880"/>
        <c:crosses val="autoZero"/>
        <c:crossBetween val="midCat"/>
        <c:majorUnit val="5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rgbClr val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190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58E8E6-5F2D-D447-A108-92ADFC0D44CC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D9A925-547A-9B41-9998-9060041CD23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11257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88545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6686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4278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1429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9141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2873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50510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5177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34568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5871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90010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1223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738042" y="531994"/>
            <a:ext cx="55267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Arial"/>
                <a:cs typeface="Arial"/>
              </a:rPr>
              <a:t>S2 </a:t>
            </a:r>
            <a:r>
              <a:rPr lang="fr-FR" b="1" dirty="0" err="1">
                <a:latin typeface="Arial"/>
                <a:cs typeface="Arial"/>
              </a:rPr>
              <a:t>Fig</a:t>
            </a:r>
            <a:r>
              <a:rPr lang="fr-FR" b="1" dirty="0">
                <a:latin typeface="Arial"/>
                <a:cs typeface="Arial"/>
              </a:rPr>
              <a:t> CRC</a:t>
            </a:r>
          </a:p>
        </p:txBody>
      </p:sp>
      <p:sp>
        <p:nvSpPr>
          <p:cNvPr id="5" name="Rectangle 4"/>
          <p:cNvSpPr/>
          <p:nvPr/>
        </p:nvSpPr>
        <p:spPr>
          <a:xfrm>
            <a:off x="313957" y="4994313"/>
            <a:ext cx="871944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dirty="0"/>
              <a:t>CRC </a:t>
            </a:r>
            <a:r>
              <a:rPr lang="fr-FR" dirty="0" err="1"/>
              <a:t>was</a:t>
            </a:r>
            <a:r>
              <a:rPr lang="fr-FR" dirty="0"/>
              <a:t> </a:t>
            </a:r>
            <a:r>
              <a:rPr lang="fr-FR" dirty="0" err="1"/>
              <a:t>performed</a:t>
            </a:r>
            <a:r>
              <a:rPr lang="fr-FR" dirty="0"/>
              <a:t> on </a:t>
            </a:r>
            <a:r>
              <a:rPr lang="fr-FR" dirty="0" err="1"/>
              <a:t>isolated</a:t>
            </a:r>
            <a:r>
              <a:rPr lang="fr-FR" dirty="0"/>
              <a:t> </a:t>
            </a:r>
            <a:r>
              <a:rPr lang="fr-FR" dirty="0" err="1"/>
              <a:t>cardiac</a:t>
            </a:r>
            <a:r>
              <a:rPr lang="fr-FR" dirty="0"/>
              <a:t> </a:t>
            </a:r>
            <a:r>
              <a:rPr lang="fr-FR" dirty="0" err="1"/>
              <a:t>mitochondria</a:t>
            </a:r>
            <a:r>
              <a:rPr lang="fr-FR" dirty="0"/>
              <a:t> </a:t>
            </a:r>
            <a:r>
              <a:rPr lang="fr-FR" dirty="0" err="1"/>
              <a:t>from</a:t>
            </a:r>
            <a:r>
              <a:rPr lang="fr-FR" dirty="0"/>
              <a:t> the </a:t>
            </a:r>
            <a:r>
              <a:rPr lang="fr-FR" dirty="0" err="1"/>
              <a:t>ischemic</a:t>
            </a:r>
            <a:r>
              <a:rPr lang="fr-FR" dirty="0"/>
              <a:t> zone </a:t>
            </a:r>
            <a:r>
              <a:rPr lang="fr-FR" dirty="0" err="1"/>
              <a:t>from</a:t>
            </a:r>
            <a:r>
              <a:rPr lang="fr-FR" dirty="0"/>
              <a:t> </a:t>
            </a:r>
            <a:r>
              <a:rPr lang="en-US" i="1" dirty="0"/>
              <a:t>Dnm1l</a:t>
            </a:r>
            <a:r>
              <a:rPr lang="en-US" i="1" baseline="30000" dirty="0"/>
              <a:t>+/- </a:t>
            </a:r>
            <a:r>
              <a:rPr lang="en-US" dirty="0"/>
              <a:t> and control WT mice after I/R, with or without the injection of cyclosporine A (10mg/kg) 10 minutes before the end of reperfusion</a:t>
            </a:r>
            <a:r>
              <a:rPr lang="fr-FR" dirty="0"/>
              <a:t>. Calcium</a:t>
            </a:r>
            <a:r>
              <a:rPr lang="fr-FR"/>
              <a:t>-green </a:t>
            </a:r>
            <a:r>
              <a:rPr lang="fr-FR" dirty="0"/>
              <a:t>Fluorescence </a:t>
            </a:r>
            <a:r>
              <a:rPr lang="fr-FR" dirty="0" err="1"/>
              <a:t>was</a:t>
            </a:r>
            <a:r>
              <a:rPr lang="fr-FR" dirty="0"/>
              <a:t> </a:t>
            </a:r>
            <a:r>
              <a:rPr lang="fr-FR" dirty="0" err="1"/>
              <a:t>expressed</a:t>
            </a:r>
            <a:r>
              <a:rPr lang="fr-FR" dirty="0"/>
              <a:t> in </a:t>
            </a:r>
            <a:r>
              <a:rPr lang="fr-FR" dirty="0" err="1"/>
              <a:t>arbitrary</a:t>
            </a:r>
            <a:r>
              <a:rPr lang="fr-FR" dirty="0"/>
              <a:t> unit, F(A.U.) and </a:t>
            </a:r>
            <a:r>
              <a:rPr lang="fr-FR" dirty="0" err="1"/>
              <a:t>represents</a:t>
            </a:r>
            <a:r>
              <a:rPr lang="fr-FR" dirty="0"/>
              <a:t> extra-mitochondrial Ca</a:t>
            </a:r>
            <a:r>
              <a:rPr lang="fr-FR" baseline="30000" dirty="0"/>
              <a:t>2+</a:t>
            </a:r>
            <a:r>
              <a:rPr lang="fr-FR" dirty="0"/>
              <a:t>. Ca</a:t>
            </a:r>
            <a:r>
              <a:rPr lang="fr-FR" baseline="30000" dirty="0"/>
              <a:t>2+</a:t>
            </a:r>
            <a:r>
              <a:rPr lang="fr-FR" dirty="0"/>
              <a:t> </a:t>
            </a:r>
            <a:r>
              <a:rPr lang="fr-FR" dirty="0" err="1"/>
              <a:t>was</a:t>
            </a:r>
            <a:r>
              <a:rPr lang="fr-FR" dirty="0"/>
              <a:t> </a:t>
            </a:r>
            <a:r>
              <a:rPr lang="fr-FR" dirty="0" err="1"/>
              <a:t>added</a:t>
            </a:r>
            <a:r>
              <a:rPr lang="fr-FR" dirty="0"/>
              <a:t> </a:t>
            </a:r>
            <a:r>
              <a:rPr lang="fr-FR" dirty="0" err="1"/>
              <a:t>every</a:t>
            </a:r>
            <a:r>
              <a:rPr lang="fr-FR" dirty="0"/>
              <a:t> 90 sec by </a:t>
            </a:r>
            <a:r>
              <a:rPr lang="fr-FR" dirty="0" err="1"/>
              <a:t>increments</a:t>
            </a:r>
            <a:r>
              <a:rPr lang="fr-FR" dirty="0"/>
              <a:t> of 10 </a:t>
            </a:r>
            <a:r>
              <a:rPr lang="fr-FR" dirty="0" err="1"/>
              <a:t>nmoles</a:t>
            </a:r>
            <a:r>
              <a:rPr lang="fr-FR" dirty="0"/>
              <a:t> per injection. </a:t>
            </a:r>
          </a:p>
          <a:p>
            <a:pPr algn="just"/>
            <a:endParaRPr lang="fr-FR" dirty="0"/>
          </a:p>
        </p:txBody>
      </p:sp>
      <p:grpSp>
        <p:nvGrpSpPr>
          <p:cNvPr id="3" name="Grouper 2"/>
          <p:cNvGrpSpPr/>
          <p:nvPr/>
        </p:nvGrpSpPr>
        <p:grpSpPr>
          <a:xfrm>
            <a:off x="7012544" y="2399652"/>
            <a:ext cx="1441420" cy="1194941"/>
            <a:chOff x="7190344" y="2374252"/>
            <a:chExt cx="1441420" cy="1194941"/>
          </a:xfrm>
        </p:grpSpPr>
        <p:sp>
          <p:nvSpPr>
            <p:cNvPr id="2" name="ZoneTexte 1"/>
            <p:cNvSpPr txBox="1"/>
            <p:nvPr/>
          </p:nvSpPr>
          <p:spPr>
            <a:xfrm>
              <a:off x="7190344" y="2374252"/>
              <a:ext cx="47961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/>
                <a:t>WT</a:t>
              </a: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7190344" y="2663519"/>
              <a:ext cx="98196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/>
                <a:t>WT + </a:t>
              </a:r>
              <a:r>
                <a:rPr lang="fr-FR" sz="1600" b="1" dirty="0" err="1"/>
                <a:t>CsA</a:t>
              </a:r>
              <a:endParaRPr lang="fr-FR" sz="1600" b="1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7190344" y="2950361"/>
              <a:ext cx="96058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/>
                <a:t>Dnm1l </a:t>
              </a:r>
              <a:r>
                <a:rPr lang="fr-FR" sz="1600" b="1" baseline="30000" dirty="0"/>
                <a:t>+/-</a:t>
              </a: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7190344" y="3230639"/>
              <a:ext cx="144142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/>
                <a:t>Dnm1l</a:t>
              </a:r>
              <a:r>
                <a:rPr lang="fr-FR" sz="1600" b="1" baseline="30000" dirty="0"/>
                <a:t> +/- </a:t>
              </a:r>
              <a:r>
                <a:rPr lang="fr-FR" sz="1600" b="1" dirty="0"/>
                <a:t>+ </a:t>
              </a:r>
              <a:r>
                <a:rPr lang="fr-FR" sz="1600" b="1" dirty="0" err="1"/>
                <a:t>CsA</a:t>
              </a:r>
              <a:endParaRPr lang="fr-FR" sz="1600" b="1" dirty="0"/>
            </a:p>
          </p:txBody>
        </p:sp>
      </p:grpSp>
      <p:graphicFrame>
        <p:nvGraphicFramePr>
          <p:cNvPr id="14" name="Graphique 13">
            <a:extLst>
              <a:ext uri="{FF2B5EF4-FFF2-40B4-BE49-F238E27FC236}">
                <a16:creationId xmlns:a16="http://schemas.microsoft.com/office/drawing/2014/main" id="{A654FA72-23FB-684E-861B-BA89C6B542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3846877"/>
              </p:ext>
            </p:extLst>
          </p:nvPr>
        </p:nvGraphicFramePr>
        <p:xfrm>
          <a:off x="1015999" y="986357"/>
          <a:ext cx="6057901" cy="40929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3064140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6</TotalTime>
  <Words>104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aura</dc:creator>
  <cp:lastModifiedBy>SATHISH</cp:lastModifiedBy>
  <cp:revision>15</cp:revision>
  <dcterms:created xsi:type="dcterms:W3CDTF">2020-06-23T12:46:22Z</dcterms:created>
  <dcterms:modified xsi:type="dcterms:W3CDTF">2021-03-18T11:08:30Z</dcterms:modified>
</cp:coreProperties>
</file>